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F8F8"/>
    <a:srgbClr val="00FF00"/>
    <a:srgbClr val="FFFF00"/>
    <a:srgbClr val="0000FF"/>
    <a:srgbClr val="FF66FF"/>
    <a:srgbClr val="9933FF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37" autoAdjust="0"/>
    <p:restoredTop sz="94660"/>
  </p:normalViewPr>
  <p:slideViewPr>
    <p:cSldViewPr snapToGrid="0">
      <p:cViewPr varScale="1">
        <p:scale>
          <a:sx n="62" d="100"/>
          <a:sy n="62" d="100"/>
        </p:scale>
        <p:origin x="856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9263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063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686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398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438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938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1120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9167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394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775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513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F2AB7-4F0F-4CF5-AF79-0F55A1D0312E}" type="datetimeFigureOut">
              <a:rPr kumimoji="1" lang="ja-JP" altLang="en-US" smtClean="0"/>
              <a:t>2025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109A2-6611-4677-88EC-5C6F303D16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952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8F8F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F0E5E794-CFB5-80B3-681E-ECA1197EEE47}"/>
              </a:ext>
            </a:extLst>
          </p:cNvPr>
          <p:cNvGrpSpPr/>
          <p:nvPr/>
        </p:nvGrpSpPr>
        <p:grpSpPr>
          <a:xfrm>
            <a:off x="-816429" y="174639"/>
            <a:ext cx="9363701" cy="6449264"/>
            <a:chOff x="-816429" y="174639"/>
            <a:chExt cx="9363701" cy="6449264"/>
          </a:xfrm>
        </p:grpSpPr>
        <p:pic>
          <p:nvPicPr>
            <p:cNvPr id="103" name="図 102">
              <a:extLst>
                <a:ext uri="{FF2B5EF4-FFF2-40B4-BE49-F238E27FC236}">
                  <a16:creationId xmlns:a16="http://schemas.microsoft.com/office/drawing/2014/main" id="{FD61FFD6-FE3F-F4C1-F5F8-C58FCF0365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969" t="6798" r="4412" b="3443"/>
            <a:stretch>
              <a:fillRect/>
            </a:stretch>
          </p:blipFill>
          <p:spPr>
            <a:xfrm>
              <a:off x="1447798" y="280264"/>
              <a:ext cx="6881865" cy="3664507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99" name="グループ化 98">
              <a:extLst>
                <a:ext uri="{FF2B5EF4-FFF2-40B4-BE49-F238E27FC236}">
                  <a16:creationId xmlns:a16="http://schemas.microsoft.com/office/drawing/2014/main" id="{7BC8C63B-13EC-1C26-4625-B56125291443}"/>
                </a:ext>
              </a:extLst>
            </p:cNvPr>
            <p:cNvGrpSpPr/>
            <p:nvPr/>
          </p:nvGrpSpPr>
          <p:grpSpPr>
            <a:xfrm>
              <a:off x="-816429" y="174639"/>
              <a:ext cx="9363701" cy="6429230"/>
              <a:chOff x="-731815" y="-108235"/>
              <a:chExt cx="9211236" cy="6588053"/>
            </a:xfrm>
          </p:grpSpPr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16F3D1E7-CE40-D722-3FC4-C91E3AD29580}"/>
                  </a:ext>
                </a:extLst>
              </p:cNvPr>
              <p:cNvGrpSpPr/>
              <p:nvPr/>
            </p:nvGrpSpPr>
            <p:grpSpPr>
              <a:xfrm>
                <a:off x="-731815" y="-108235"/>
                <a:ext cx="8997171" cy="6588053"/>
                <a:chOff x="-708208" y="-101942"/>
                <a:chExt cx="8997171" cy="6588052"/>
              </a:xfrm>
            </p:grpSpPr>
            <p:grpSp>
              <p:nvGrpSpPr>
                <p:cNvPr id="24" name="グループ化 23">
                  <a:extLst>
                    <a:ext uri="{FF2B5EF4-FFF2-40B4-BE49-F238E27FC236}">
                      <a16:creationId xmlns:a16="http://schemas.microsoft.com/office/drawing/2014/main" id="{3F6AF5F5-B3B4-A8CC-1380-2A801B04F227}"/>
                    </a:ext>
                  </a:extLst>
                </p:cNvPr>
                <p:cNvGrpSpPr/>
                <p:nvPr/>
              </p:nvGrpSpPr>
              <p:grpSpPr>
                <a:xfrm>
                  <a:off x="-708208" y="3024900"/>
                  <a:ext cx="8997171" cy="3397758"/>
                  <a:chOff x="-708208" y="3024900"/>
                  <a:chExt cx="8997171" cy="3397758"/>
                </a:xfrm>
              </p:grpSpPr>
              <p:pic>
                <p:nvPicPr>
                  <p:cNvPr id="9" name="図 8">
                    <a:extLst>
                      <a:ext uri="{FF2B5EF4-FFF2-40B4-BE49-F238E27FC236}">
                        <a16:creationId xmlns:a16="http://schemas.microsoft.com/office/drawing/2014/main" id="{E6493489-4D38-3E5B-566C-639BABF6DD8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3236" t="15077" r="4412" b="3704"/>
                  <a:stretch/>
                </p:blipFill>
                <p:spPr>
                  <a:xfrm>
                    <a:off x="1464983" y="3024900"/>
                    <a:ext cx="6823980" cy="3397758"/>
                  </a:xfrm>
                  <a:prstGeom prst="rect">
                    <a:avLst/>
                  </a:prstGeom>
                  <a:ln>
                    <a:noFill/>
                  </a:ln>
                </p:spPr>
              </p:pic>
              <p:sp>
                <p:nvSpPr>
                  <p:cNvPr id="6" name="テキスト ボックス 5">
                    <a:extLst>
                      <a:ext uri="{FF2B5EF4-FFF2-40B4-BE49-F238E27FC236}">
                        <a16:creationId xmlns:a16="http://schemas.microsoft.com/office/drawing/2014/main" id="{0466E6BC-EEBB-7298-8BFA-8FC6DE0E8BF5}"/>
                      </a:ext>
                    </a:extLst>
                  </p:cNvPr>
                  <p:cNvSpPr txBox="1"/>
                  <p:nvPr/>
                </p:nvSpPr>
                <p:spPr>
                  <a:xfrm>
                    <a:off x="-708208" y="4996618"/>
                    <a:ext cx="224742" cy="31538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b="1" dirty="0"/>
                      <a:t> </a:t>
                    </a:r>
                    <a:endParaRPr kumimoji="1" lang="ja-JP" altLang="en-US" sz="1400" dirty="0"/>
                  </a:p>
                </p:txBody>
              </p:sp>
            </p:grpSp>
            <p:sp>
              <p:nvSpPr>
                <p:cNvPr id="4" name="正方形/長方形 3">
                  <a:extLst>
                    <a:ext uri="{FF2B5EF4-FFF2-40B4-BE49-F238E27FC236}">
                      <a16:creationId xmlns:a16="http://schemas.microsoft.com/office/drawing/2014/main" id="{C8535E4A-BE08-E810-5206-E3EABE0072CF}"/>
                    </a:ext>
                  </a:extLst>
                </p:cNvPr>
                <p:cNvSpPr/>
                <p:nvPr/>
              </p:nvSpPr>
              <p:spPr>
                <a:xfrm>
                  <a:off x="3666391" y="3018607"/>
                  <a:ext cx="230373" cy="10487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" name="正方形/長方形 10">
                  <a:extLst>
                    <a:ext uri="{FF2B5EF4-FFF2-40B4-BE49-F238E27FC236}">
                      <a16:creationId xmlns:a16="http://schemas.microsoft.com/office/drawing/2014/main" id="{53119C85-2933-0E59-103C-AF3A98BC4073}"/>
                    </a:ext>
                  </a:extLst>
                </p:cNvPr>
                <p:cNvSpPr/>
                <p:nvPr/>
              </p:nvSpPr>
              <p:spPr>
                <a:xfrm>
                  <a:off x="4572000" y="832760"/>
                  <a:ext cx="272374" cy="130277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818AFD95-79BF-DE0B-0640-4CEC5C65D397}"/>
                    </a:ext>
                  </a:extLst>
                </p:cNvPr>
                <p:cNvSpPr txBox="1"/>
                <p:nvPr/>
              </p:nvSpPr>
              <p:spPr>
                <a:xfrm>
                  <a:off x="4903027" y="-101942"/>
                  <a:ext cx="668773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/>
                    <a:t>Cluster 7</a:t>
                  </a:r>
                  <a:endParaRPr kumimoji="1" lang="ja-JP" altLang="en-US" sz="1000" b="1" dirty="0"/>
                </a:p>
              </p:txBody>
            </p: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3A8BD16A-7A5F-E9F5-C717-9D584BC96145}"/>
                    </a:ext>
                  </a:extLst>
                </p:cNvPr>
                <p:cNvSpPr txBox="1"/>
                <p:nvPr/>
              </p:nvSpPr>
              <p:spPr>
                <a:xfrm>
                  <a:off x="4558833" y="2054780"/>
                  <a:ext cx="652743" cy="24622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/>
                    <a:t>Cluster 6</a:t>
                  </a:r>
                </a:p>
              </p:txBody>
            </p:sp>
            <p:sp>
              <p:nvSpPr>
                <p:cNvPr id="12" name="正方形/長方形 11">
                  <a:extLst>
                    <a:ext uri="{FF2B5EF4-FFF2-40B4-BE49-F238E27FC236}">
                      <a16:creationId xmlns:a16="http://schemas.microsoft.com/office/drawing/2014/main" id="{A313C22C-C3B9-FF11-C943-ED2781859961}"/>
                    </a:ext>
                  </a:extLst>
                </p:cNvPr>
                <p:cNvSpPr/>
                <p:nvPr/>
              </p:nvSpPr>
              <p:spPr>
                <a:xfrm>
                  <a:off x="4232642" y="2638666"/>
                  <a:ext cx="242151" cy="11647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" name="正方形/長方形 7">
                  <a:extLst>
                    <a:ext uri="{FF2B5EF4-FFF2-40B4-BE49-F238E27FC236}">
                      <a16:creationId xmlns:a16="http://schemas.microsoft.com/office/drawing/2014/main" id="{05D4215E-E217-C6F8-B242-D090D091EF33}"/>
                    </a:ext>
                  </a:extLst>
                </p:cNvPr>
                <p:cNvSpPr/>
                <p:nvPr/>
              </p:nvSpPr>
              <p:spPr>
                <a:xfrm>
                  <a:off x="4431613" y="3135978"/>
                  <a:ext cx="245454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0" name="正方形/長方形 19">
                  <a:extLst>
                    <a:ext uri="{FF2B5EF4-FFF2-40B4-BE49-F238E27FC236}">
                      <a16:creationId xmlns:a16="http://schemas.microsoft.com/office/drawing/2014/main" id="{52FD4EC1-0B50-3BC7-0D56-6C3846DFD7D5}"/>
                    </a:ext>
                  </a:extLst>
                </p:cNvPr>
                <p:cNvSpPr/>
                <p:nvPr/>
              </p:nvSpPr>
              <p:spPr>
                <a:xfrm>
                  <a:off x="3892229" y="3089503"/>
                  <a:ext cx="230373" cy="9111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1" name="正方形/長方形 20">
                  <a:extLst>
                    <a:ext uri="{FF2B5EF4-FFF2-40B4-BE49-F238E27FC236}">
                      <a16:creationId xmlns:a16="http://schemas.microsoft.com/office/drawing/2014/main" id="{2A072190-8C41-A7C0-BB0A-3F3413DB699F}"/>
                    </a:ext>
                  </a:extLst>
                </p:cNvPr>
                <p:cNvSpPr/>
                <p:nvPr/>
              </p:nvSpPr>
              <p:spPr>
                <a:xfrm>
                  <a:off x="4063656" y="2577377"/>
                  <a:ext cx="156897" cy="12099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5" name="正方形/長方形 24">
                  <a:extLst>
                    <a:ext uri="{FF2B5EF4-FFF2-40B4-BE49-F238E27FC236}">
                      <a16:creationId xmlns:a16="http://schemas.microsoft.com/office/drawing/2014/main" id="{D86EAEFE-B727-F400-F558-98ED0B71B2CE}"/>
                    </a:ext>
                  </a:extLst>
                </p:cNvPr>
                <p:cNvSpPr/>
                <p:nvPr/>
              </p:nvSpPr>
              <p:spPr>
                <a:xfrm>
                  <a:off x="4153951" y="1362134"/>
                  <a:ext cx="220331" cy="10632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33" name="直線コネクタ 32">
                  <a:extLst>
                    <a:ext uri="{FF2B5EF4-FFF2-40B4-BE49-F238E27FC236}">
                      <a16:creationId xmlns:a16="http://schemas.microsoft.com/office/drawing/2014/main" id="{E09EF937-FEE9-01FA-1AA1-80B1092BD8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270501" y="3266266"/>
                  <a:ext cx="324190" cy="421205"/>
                </a:xfrm>
                <a:prstGeom prst="line">
                  <a:avLst/>
                </a:prstGeom>
                <a:ln w="12700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" name="正方形/長方形 17">
                  <a:extLst>
                    <a:ext uri="{FF2B5EF4-FFF2-40B4-BE49-F238E27FC236}">
                      <a16:creationId xmlns:a16="http://schemas.microsoft.com/office/drawing/2014/main" id="{504BFB1A-D126-70F2-AC41-3C57DA7B1829}"/>
                    </a:ext>
                  </a:extLst>
                </p:cNvPr>
                <p:cNvSpPr/>
                <p:nvPr/>
              </p:nvSpPr>
              <p:spPr>
                <a:xfrm>
                  <a:off x="4790154" y="2577378"/>
                  <a:ext cx="245454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6" name="正方形/長方形 25">
                  <a:extLst>
                    <a:ext uri="{FF2B5EF4-FFF2-40B4-BE49-F238E27FC236}">
                      <a16:creationId xmlns:a16="http://schemas.microsoft.com/office/drawing/2014/main" id="{02C73F4F-9145-2456-5DF7-EA8BDEE077BB}"/>
                    </a:ext>
                  </a:extLst>
                </p:cNvPr>
                <p:cNvSpPr/>
                <p:nvPr/>
              </p:nvSpPr>
              <p:spPr>
                <a:xfrm>
                  <a:off x="5470666" y="2596996"/>
                  <a:ext cx="245454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8" name="正方形/長方形 27">
                  <a:extLst>
                    <a:ext uri="{FF2B5EF4-FFF2-40B4-BE49-F238E27FC236}">
                      <a16:creationId xmlns:a16="http://schemas.microsoft.com/office/drawing/2014/main" id="{B937714B-4B20-AA4F-8D86-732B483152AA}"/>
                    </a:ext>
                  </a:extLst>
                </p:cNvPr>
                <p:cNvSpPr/>
                <p:nvPr/>
              </p:nvSpPr>
              <p:spPr>
                <a:xfrm>
                  <a:off x="4939881" y="2198363"/>
                  <a:ext cx="245454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" name="テキスト ボックス 1">
                  <a:extLst>
                    <a:ext uri="{FF2B5EF4-FFF2-40B4-BE49-F238E27FC236}">
                      <a16:creationId xmlns:a16="http://schemas.microsoft.com/office/drawing/2014/main" id="{DC87C0EB-1B8B-4035-11A8-D5A45EB8D682}"/>
                    </a:ext>
                  </a:extLst>
                </p:cNvPr>
                <p:cNvSpPr txBox="1"/>
                <p:nvPr/>
              </p:nvSpPr>
              <p:spPr>
                <a:xfrm>
                  <a:off x="2307253" y="-20486"/>
                  <a:ext cx="676788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/>
                    <a:t>Cluster 3</a:t>
                  </a:r>
                  <a:endParaRPr kumimoji="1" lang="ja-JP" altLang="en-US" sz="1000" b="1" dirty="0"/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966E7427-AD83-EF63-1B53-FB6C0520EF3D}"/>
                    </a:ext>
                  </a:extLst>
                </p:cNvPr>
                <p:cNvSpPr txBox="1"/>
                <p:nvPr/>
              </p:nvSpPr>
              <p:spPr>
                <a:xfrm rot="21419615">
                  <a:off x="4014848" y="2915444"/>
                  <a:ext cx="745717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/>
                    <a:t>Cluster 10</a:t>
                  </a:r>
                  <a:endParaRPr kumimoji="1" lang="ja-JP" altLang="en-US" sz="1000" b="1" dirty="0"/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389C94CA-9E1B-1509-4F2F-39A7B99ECA3B}"/>
                    </a:ext>
                  </a:extLst>
                </p:cNvPr>
                <p:cNvSpPr txBox="1"/>
                <p:nvPr/>
              </p:nvSpPr>
              <p:spPr>
                <a:xfrm>
                  <a:off x="1471282" y="2306747"/>
                  <a:ext cx="668773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/>
                    <a:t>Cluster 5</a:t>
                  </a:r>
                  <a:endParaRPr kumimoji="1" lang="ja-JP" altLang="en-US" sz="1000" b="1" dirty="0"/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B1B9F54F-3DB7-6FD2-99BF-3DE19F526648}"/>
                    </a:ext>
                  </a:extLst>
                </p:cNvPr>
                <p:cNvSpPr txBox="1"/>
                <p:nvPr/>
              </p:nvSpPr>
              <p:spPr>
                <a:xfrm>
                  <a:off x="4600444" y="6224500"/>
                  <a:ext cx="743624" cy="2616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b="1" dirty="0"/>
                    <a:t>Cluster 9</a:t>
                  </a:r>
                  <a:endParaRPr kumimoji="1" lang="ja-JP" altLang="en-US" sz="1050" b="1" dirty="0"/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24396B98-54E3-0C56-88F3-28BC5B1669DC}"/>
                    </a:ext>
                  </a:extLst>
                </p:cNvPr>
                <p:cNvSpPr txBox="1"/>
                <p:nvPr/>
              </p:nvSpPr>
              <p:spPr>
                <a:xfrm>
                  <a:off x="7456740" y="162332"/>
                  <a:ext cx="72351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b="1" dirty="0"/>
                    <a:t>Cluster 8</a:t>
                  </a:r>
                  <a:endParaRPr kumimoji="1" lang="ja-JP" altLang="en-US" sz="1000" b="1" dirty="0"/>
                </a:p>
              </p:txBody>
            </p:sp>
            <p:sp>
              <p:nvSpPr>
                <p:cNvPr id="47" name="フリーフォーム: 図形 46">
                  <a:extLst>
                    <a:ext uri="{FF2B5EF4-FFF2-40B4-BE49-F238E27FC236}">
                      <a16:creationId xmlns:a16="http://schemas.microsoft.com/office/drawing/2014/main" id="{8002B49A-356C-3BBE-F94E-8BB873A4CCDB}"/>
                    </a:ext>
                  </a:extLst>
                </p:cNvPr>
                <p:cNvSpPr/>
                <p:nvPr/>
              </p:nvSpPr>
              <p:spPr>
                <a:xfrm>
                  <a:off x="4508405" y="1542258"/>
                  <a:ext cx="1780051" cy="1852291"/>
                </a:xfrm>
                <a:custGeom>
                  <a:avLst/>
                  <a:gdLst>
                    <a:gd name="connsiteX0" fmla="*/ 465261 w 1801075"/>
                    <a:gd name="connsiteY0" fmla="*/ 156656 h 1863681"/>
                    <a:gd name="connsiteX1" fmla="*/ 252248 w 1801075"/>
                    <a:gd name="connsiteY1" fmla="*/ 535924 h 1863681"/>
                    <a:gd name="connsiteX2" fmla="*/ 44430 w 1801075"/>
                    <a:gd name="connsiteY2" fmla="*/ 998319 h 1863681"/>
                    <a:gd name="connsiteX3" fmla="*/ 23648 w 1801075"/>
                    <a:gd name="connsiteY3" fmla="*/ 1252897 h 1863681"/>
                    <a:gd name="connsiteX4" fmla="*/ 319789 w 1801075"/>
                    <a:gd name="connsiteY4" fmla="*/ 1445128 h 1863681"/>
                    <a:gd name="connsiteX5" fmla="*/ 1041957 w 1801075"/>
                    <a:gd name="connsiteY5" fmla="*/ 1798419 h 1863681"/>
                    <a:gd name="connsiteX6" fmla="*/ 1566698 w 1801075"/>
                    <a:gd name="connsiteY6" fmla="*/ 1845178 h 1863681"/>
                    <a:gd name="connsiteX7" fmla="*/ 1790102 w 1801075"/>
                    <a:gd name="connsiteY7" fmla="*/ 1585406 h 1863681"/>
                    <a:gd name="connsiteX8" fmla="*/ 1732952 w 1801075"/>
                    <a:gd name="connsiteY8" fmla="*/ 1185356 h 1863681"/>
                    <a:gd name="connsiteX9" fmla="*/ 1442007 w 1801075"/>
                    <a:gd name="connsiteY9" fmla="*/ 655419 h 1863681"/>
                    <a:gd name="connsiteX10" fmla="*/ 1062739 w 1801075"/>
                    <a:gd name="connsiteY10" fmla="*/ 104701 h 1863681"/>
                    <a:gd name="connsiteX11" fmla="*/ 870507 w 1801075"/>
                    <a:gd name="connsiteY11" fmla="*/ 792 h 1863681"/>
                    <a:gd name="connsiteX12" fmla="*/ 465261 w 1801075"/>
                    <a:gd name="connsiteY12" fmla="*/ 156656 h 186368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1801075" h="1863681">
                      <a:moveTo>
                        <a:pt x="465261" y="156656"/>
                      </a:moveTo>
                      <a:cubicBezTo>
                        <a:pt x="362218" y="245845"/>
                        <a:pt x="322386" y="395647"/>
                        <a:pt x="252248" y="535924"/>
                      </a:cubicBezTo>
                      <a:cubicBezTo>
                        <a:pt x="182110" y="676201"/>
                        <a:pt x="82530" y="878824"/>
                        <a:pt x="44430" y="998319"/>
                      </a:cubicBezTo>
                      <a:cubicBezTo>
                        <a:pt x="6330" y="1117814"/>
                        <a:pt x="-22245" y="1178429"/>
                        <a:pt x="23648" y="1252897"/>
                      </a:cubicBezTo>
                      <a:cubicBezTo>
                        <a:pt x="69541" y="1327365"/>
                        <a:pt x="150071" y="1354208"/>
                        <a:pt x="319789" y="1445128"/>
                      </a:cubicBezTo>
                      <a:cubicBezTo>
                        <a:pt x="489507" y="1536048"/>
                        <a:pt x="834139" y="1731744"/>
                        <a:pt x="1041957" y="1798419"/>
                      </a:cubicBezTo>
                      <a:cubicBezTo>
                        <a:pt x="1249775" y="1865094"/>
                        <a:pt x="1442007" y="1880680"/>
                        <a:pt x="1566698" y="1845178"/>
                      </a:cubicBezTo>
                      <a:cubicBezTo>
                        <a:pt x="1691389" y="1809676"/>
                        <a:pt x="1762393" y="1695376"/>
                        <a:pt x="1790102" y="1585406"/>
                      </a:cubicBezTo>
                      <a:cubicBezTo>
                        <a:pt x="1817811" y="1475436"/>
                        <a:pt x="1790968" y="1340354"/>
                        <a:pt x="1732952" y="1185356"/>
                      </a:cubicBezTo>
                      <a:cubicBezTo>
                        <a:pt x="1674936" y="1030358"/>
                        <a:pt x="1553709" y="835528"/>
                        <a:pt x="1442007" y="655419"/>
                      </a:cubicBezTo>
                      <a:cubicBezTo>
                        <a:pt x="1330305" y="475310"/>
                        <a:pt x="1157989" y="213806"/>
                        <a:pt x="1062739" y="104701"/>
                      </a:cubicBezTo>
                      <a:cubicBezTo>
                        <a:pt x="967489" y="-4404"/>
                        <a:pt x="970087" y="-1806"/>
                        <a:pt x="870507" y="792"/>
                      </a:cubicBezTo>
                      <a:cubicBezTo>
                        <a:pt x="770927" y="3390"/>
                        <a:pt x="568304" y="67467"/>
                        <a:pt x="465261" y="156656"/>
                      </a:cubicBezTo>
                      <a:close/>
                    </a:path>
                  </a:pathLst>
                </a:custGeom>
                <a:noFill/>
                <a:ln w="19050">
                  <a:solidFill>
                    <a:srgbClr val="7030A0"/>
                  </a:solidFill>
                  <a:prstDash val="solid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9" name="正方形/長方形 48">
                  <a:extLst>
                    <a:ext uri="{FF2B5EF4-FFF2-40B4-BE49-F238E27FC236}">
                      <a16:creationId xmlns:a16="http://schemas.microsoft.com/office/drawing/2014/main" id="{F79FB93E-5041-7700-20E1-C1C1A13BB67E}"/>
                    </a:ext>
                  </a:extLst>
                </p:cNvPr>
                <p:cNvSpPr/>
                <p:nvPr/>
              </p:nvSpPr>
              <p:spPr>
                <a:xfrm>
                  <a:off x="3025047" y="1693836"/>
                  <a:ext cx="245454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" name="フリーフォーム: 図形 16">
                  <a:extLst>
                    <a:ext uri="{FF2B5EF4-FFF2-40B4-BE49-F238E27FC236}">
                      <a16:creationId xmlns:a16="http://schemas.microsoft.com/office/drawing/2014/main" id="{E2DED285-A0EA-8F50-04D1-DFBA19DD5A0B}"/>
                    </a:ext>
                  </a:extLst>
                </p:cNvPr>
                <p:cNvSpPr/>
                <p:nvPr/>
              </p:nvSpPr>
              <p:spPr>
                <a:xfrm>
                  <a:off x="5180453" y="3143991"/>
                  <a:ext cx="2391211" cy="1973913"/>
                </a:xfrm>
                <a:custGeom>
                  <a:avLst/>
                  <a:gdLst>
                    <a:gd name="connsiteX0" fmla="*/ 1335411 w 2424823"/>
                    <a:gd name="connsiteY0" fmla="*/ 42201 h 1980145"/>
                    <a:gd name="connsiteX1" fmla="*/ 1142422 w 2424823"/>
                    <a:gd name="connsiteY1" fmla="*/ 184645 h 1980145"/>
                    <a:gd name="connsiteX2" fmla="*/ 917268 w 2424823"/>
                    <a:gd name="connsiteY2" fmla="*/ 437368 h 1980145"/>
                    <a:gd name="connsiteX3" fmla="*/ 375061 w 2424823"/>
                    <a:gd name="connsiteY3" fmla="*/ 745232 h 1980145"/>
                    <a:gd name="connsiteX4" fmla="*/ 131527 w 2424823"/>
                    <a:gd name="connsiteY4" fmla="*/ 974980 h 1980145"/>
                    <a:gd name="connsiteX5" fmla="*/ 2868 w 2424823"/>
                    <a:gd name="connsiteY5" fmla="*/ 1241489 h 1980145"/>
                    <a:gd name="connsiteX6" fmla="*/ 76388 w 2424823"/>
                    <a:gd name="connsiteY6" fmla="*/ 1429883 h 1980145"/>
                    <a:gd name="connsiteX7" fmla="*/ 439391 w 2424823"/>
                    <a:gd name="connsiteY7" fmla="*/ 1834241 h 1980145"/>
                    <a:gd name="connsiteX8" fmla="*/ 972408 w 2424823"/>
                    <a:gd name="connsiteY8" fmla="*/ 1958305 h 1980145"/>
                    <a:gd name="connsiteX9" fmla="*/ 1551374 w 2424823"/>
                    <a:gd name="connsiteY9" fmla="*/ 1953710 h 1980145"/>
                    <a:gd name="connsiteX10" fmla="*/ 1978707 w 2424823"/>
                    <a:gd name="connsiteY10" fmla="*/ 1696392 h 1980145"/>
                    <a:gd name="connsiteX11" fmla="*/ 2295760 w 2424823"/>
                    <a:gd name="connsiteY11" fmla="*/ 1273654 h 1980145"/>
                    <a:gd name="connsiteX12" fmla="*/ 2424420 w 2424823"/>
                    <a:gd name="connsiteY12" fmla="*/ 717662 h 1980145"/>
                    <a:gd name="connsiteX13" fmla="*/ 2332520 w 2424823"/>
                    <a:gd name="connsiteY13" fmla="*/ 354659 h 1980145"/>
                    <a:gd name="connsiteX14" fmla="*/ 2226836 w 2424823"/>
                    <a:gd name="connsiteY14" fmla="*/ 184645 h 1980145"/>
                    <a:gd name="connsiteX15" fmla="*/ 1974112 w 2424823"/>
                    <a:gd name="connsiteY15" fmla="*/ 46796 h 1980145"/>
                    <a:gd name="connsiteX16" fmla="*/ 1597324 w 2424823"/>
                    <a:gd name="connsiteY16" fmla="*/ 846 h 1980145"/>
                    <a:gd name="connsiteX17" fmla="*/ 1261891 w 2424823"/>
                    <a:gd name="connsiteY17" fmla="*/ 78960 h 1980145"/>
                    <a:gd name="connsiteX18" fmla="*/ 1234321 w 2424823"/>
                    <a:gd name="connsiteY18" fmla="*/ 92745 h 198014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2424823" h="1980145">
                      <a:moveTo>
                        <a:pt x="1335411" y="42201"/>
                      </a:moveTo>
                      <a:cubicBezTo>
                        <a:pt x="1273761" y="80492"/>
                        <a:pt x="1212112" y="118784"/>
                        <a:pt x="1142422" y="184645"/>
                      </a:cubicBezTo>
                      <a:cubicBezTo>
                        <a:pt x="1072732" y="250506"/>
                        <a:pt x="1045161" y="343937"/>
                        <a:pt x="917268" y="437368"/>
                      </a:cubicBezTo>
                      <a:cubicBezTo>
                        <a:pt x="789375" y="530799"/>
                        <a:pt x="506018" y="655630"/>
                        <a:pt x="375061" y="745232"/>
                      </a:cubicBezTo>
                      <a:cubicBezTo>
                        <a:pt x="244104" y="834834"/>
                        <a:pt x="193559" y="892271"/>
                        <a:pt x="131527" y="974980"/>
                      </a:cubicBezTo>
                      <a:cubicBezTo>
                        <a:pt x="69495" y="1057690"/>
                        <a:pt x="12058" y="1165672"/>
                        <a:pt x="2868" y="1241489"/>
                      </a:cubicBezTo>
                      <a:cubicBezTo>
                        <a:pt x="-6322" y="1317306"/>
                        <a:pt x="3634" y="1331091"/>
                        <a:pt x="76388" y="1429883"/>
                      </a:cubicBezTo>
                      <a:cubicBezTo>
                        <a:pt x="149142" y="1528675"/>
                        <a:pt x="290054" y="1746171"/>
                        <a:pt x="439391" y="1834241"/>
                      </a:cubicBezTo>
                      <a:cubicBezTo>
                        <a:pt x="588728" y="1922311"/>
                        <a:pt x="787077" y="1938394"/>
                        <a:pt x="972408" y="1958305"/>
                      </a:cubicBezTo>
                      <a:cubicBezTo>
                        <a:pt x="1157738" y="1978217"/>
                        <a:pt x="1383657" y="1997362"/>
                        <a:pt x="1551374" y="1953710"/>
                      </a:cubicBezTo>
                      <a:cubicBezTo>
                        <a:pt x="1719091" y="1910058"/>
                        <a:pt x="1854643" y="1809735"/>
                        <a:pt x="1978707" y="1696392"/>
                      </a:cubicBezTo>
                      <a:cubicBezTo>
                        <a:pt x="2102771" y="1583049"/>
                        <a:pt x="2221475" y="1436776"/>
                        <a:pt x="2295760" y="1273654"/>
                      </a:cubicBezTo>
                      <a:cubicBezTo>
                        <a:pt x="2370045" y="1110532"/>
                        <a:pt x="2418293" y="870828"/>
                        <a:pt x="2424420" y="717662"/>
                      </a:cubicBezTo>
                      <a:cubicBezTo>
                        <a:pt x="2430547" y="564496"/>
                        <a:pt x="2365451" y="443495"/>
                        <a:pt x="2332520" y="354659"/>
                      </a:cubicBezTo>
                      <a:cubicBezTo>
                        <a:pt x="2299589" y="265823"/>
                        <a:pt x="2286571" y="235955"/>
                        <a:pt x="2226836" y="184645"/>
                      </a:cubicBezTo>
                      <a:cubicBezTo>
                        <a:pt x="2167101" y="133335"/>
                        <a:pt x="2079031" y="77429"/>
                        <a:pt x="1974112" y="46796"/>
                      </a:cubicBezTo>
                      <a:cubicBezTo>
                        <a:pt x="1869193" y="16163"/>
                        <a:pt x="1716027" y="-4515"/>
                        <a:pt x="1597324" y="846"/>
                      </a:cubicBezTo>
                      <a:cubicBezTo>
                        <a:pt x="1478621" y="6207"/>
                        <a:pt x="1322391" y="63644"/>
                        <a:pt x="1261891" y="78960"/>
                      </a:cubicBezTo>
                      <a:cubicBezTo>
                        <a:pt x="1201391" y="94276"/>
                        <a:pt x="1217856" y="93510"/>
                        <a:pt x="1234321" y="92745"/>
                      </a:cubicBezTo>
                    </a:path>
                  </a:pathLst>
                </a:custGeom>
                <a:noFill/>
                <a:ln>
                  <a:solidFill>
                    <a:srgbClr val="0070C0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" name="正方形/長方形 2">
                  <a:extLst>
                    <a:ext uri="{FF2B5EF4-FFF2-40B4-BE49-F238E27FC236}">
                      <a16:creationId xmlns:a16="http://schemas.microsoft.com/office/drawing/2014/main" id="{5367CCE7-EC17-43D4-EEF6-A0440FFF8A79}"/>
                    </a:ext>
                  </a:extLst>
                </p:cNvPr>
                <p:cNvSpPr/>
                <p:nvPr/>
              </p:nvSpPr>
              <p:spPr>
                <a:xfrm>
                  <a:off x="5125124" y="4509477"/>
                  <a:ext cx="254255" cy="105508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98" name="グループ化 97">
                <a:extLst>
                  <a:ext uri="{FF2B5EF4-FFF2-40B4-BE49-F238E27FC236}">
                    <a16:creationId xmlns:a16="http://schemas.microsoft.com/office/drawing/2014/main" id="{275C1E7C-FAC1-97C0-BCB2-957365CC727F}"/>
                  </a:ext>
                </a:extLst>
              </p:cNvPr>
              <p:cNvGrpSpPr/>
              <p:nvPr/>
            </p:nvGrpSpPr>
            <p:grpSpPr>
              <a:xfrm>
                <a:off x="1379807" y="3345"/>
                <a:ext cx="7099614" cy="6470446"/>
                <a:chOff x="1379807" y="3345"/>
                <a:chExt cx="7099614" cy="6470445"/>
              </a:xfrm>
            </p:grpSpPr>
            <p:sp>
              <p:nvSpPr>
                <p:cNvPr id="37" name="フリーフォーム: 図形 36">
                  <a:extLst>
                    <a:ext uri="{FF2B5EF4-FFF2-40B4-BE49-F238E27FC236}">
                      <a16:creationId xmlns:a16="http://schemas.microsoft.com/office/drawing/2014/main" id="{C06D9B51-875E-1C13-1E9B-33C0D0F93AA2}"/>
                    </a:ext>
                  </a:extLst>
                </p:cNvPr>
                <p:cNvSpPr/>
                <p:nvPr/>
              </p:nvSpPr>
              <p:spPr>
                <a:xfrm>
                  <a:off x="1479569" y="203689"/>
                  <a:ext cx="1904436" cy="1852708"/>
                </a:xfrm>
                <a:custGeom>
                  <a:avLst/>
                  <a:gdLst>
                    <a:gd name="connsiteX0" fmla="*/ 680879 w 1904436"/>
                    <a:gd name="connsiteY0" fmla="*/ 1814624 h 1852708"/>
                    <a:gd name="connsiteX1" fmla="*/ 955672 w 1904436"/>
                    <a:gd name="connsiteY1" fmla="*/ 1852527 h 1852708"/>
                    <a:gd name="connsiteX2" fmla="*/ 1292058 w 1904436"/>
                    <a:gd name="connsiteY2" fmla="*/ 1824100 h 1852708"/>
                    <a:gd name="connsiteX3" fmla="*/ 1562114 w 1904436"/>
                    <a:gd name="connsiteY3" fmla="*/ 1724605 h 1852708"/>
                    <a:gd name="connsiteX4" fmla="*/ 1765840 w 1904436"/>
                    <a:gd name="connsiteY4" fmla="*/ 1568257 h 1852708"/>
                    <a:gd name="connsiteX5" fmla="*/ 1846383 w 1904436"/>
                    <a:gd name="connsiteY5" fmla="*/ 1331366 h 1852708"/>
                    <a:gd name="connsiteX6" fmla="*/ 1898499 w 1904436"/>
                    <a:gd name="connsiteY6" fmla="*/ 1028145 h 1852708"/>
                    <a:gd name="connsiteX7" fmla="*/ 1898499 w 1904436"/>
                    <a:gd name="connsiteY7" fmla="*/ 663333 h 1852708"/>
                    <a:gd name="connsiteX8" fmla="*/ 1855859 w 1904436"/>
                    <a:gd name="connsiteY8" fmla="*/ 445393 h 1852708"/>
                    <a:gd name="connsiteX9" fmla="*/ 1794267 w 1904436"/>
                    <a:gd name="connsiteY9" fmla="*/ 322209 h 1852708"/>
                    <a:gd name="connsiteX10" fmla="*/ 1604754 w 1904436"/>
                    <a:gd name="connsiteY10" fmla="*/ 184813 h 1852708"/>
                    <a:gd name="connsiteX11" fmla="*/ 1235204 w 1904436"/>
                    <a:gd name="connsiteY11" fmla="*/ 47416 h 1852708"/>
                    <a:gd name="connsiteX12" fmla="*/ 1050429 w 1904436"/>
                    <a:gd name="connsiteY12" fmla="*/ 18989 h 1852708"/>
                    <a:gd name="connsiteX13" fmla="*/ 898819 w 1904436"/>
                    <a:gd name="connsiteY13" fmla="*/ 37 h 1852708"/>
                    <a:gd name="connsiteX14" fmla="*/ 590860 w 1904436"/>
                    <a:gd name="connsiteY14" fmla="*/ 23727 h 1852708"/>
                    <a:gd name="connsiteX15" fmla="*/ 325542 w 1904436"/>
                    <a:gd name="connsiteY15" fmla="*/ 142172 h 1852708"/>
                    <a:gd name="connsiteX16" fmla="*/ 102864 w 1904436"/>
                    <a:gd name="connsiteY16" fmla="*/ 483295 h 1852708"/>
                    <a:gd name="connsiteX17" fmla="*/ 3370 w 1904436"/>
                    <a:gd name="connsiteY17" fmla="*/ 1013932 h 1852708"/>
                    <a:gd name="connsiteX18" fmla="*/ 216572 w 1904436"/>
                    <a:gd name="connsiteY18" fmla="*/ 1535092 h 1852708"/>
                    <a:gd name="connsiteX19" fmla="*/ 481890 w 1904436"/>
                    <a:gd name="connsiteY19" fmla="*/ 1738819 h 1852708"/>
                    <a:gd name="connsiteX20" fmla="*/ 680879 w 1904436"/>
                    <a:gd name="connsiteY20" fmla="*/ 1814624 h 185270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</a:cxnLst>
                  <a:rect l="l" t="t" r="r" b="b"/>
                  <a:pathLst>
                    <a:path w="1904436" h="1852708">
                      <a:moveTo>
                        <a:pt x="680879" y="1814624"/>
                      </a:moveTo>
                      <a:cubicBezTo>
                        <a:pt x="759843" y="1833575"/>
                        <a:pt x="853809" y="1850948"/>
                        <a:pt x="955672" y="1852527"/>
                      </a:cubicBezTo>
                      <a:cubicBezTo>
                        <a:pt x="1057535" y="1854106"/>
                        <a:pt x="1190984" y="1845420"/>
                        <a:pt x="1292058" y="1824100"/>
                      </a:cubicBezTo>
                      <a:cubicBezTo>
                        <a:pt x="1393132" y="1802780"/>
                        <a:pt x="1483150" y="1767246"/>
                        <a:pt x="1562114" y="1724605"/>
                      </a:cubicBezTo>
                      <a:cubicBezTo>
                        <a:pt x="1641078" y="1681964"/>
                        <a:pt x="1718462" y="1633797"/>
                        <a:pt x="1765840" y="1568257"/>
                      </a:cubicBezTo>
                      <a:cubicBezTo>
                        <a:pt x="1813218" y="1502717"/>
                        <a:pt x="1824273" y="1421385"/>
                        <a:pt x="1846383" y="1331366"/>
                      </a:cubicBezTo>
                      <a:cubicBezTo>
                        <a:pt x="1868493" y="1241347"/>
                        <a:pt x="1889813" y="1139484"/>
                        <a:pt x="1898499" y="1028145"/>
                      </a:cubicBezTo>
                      <a:cubicBezTo>
                        <a:pt x="1907185" y="916806"/>
                        <a:pt x="1905606" y="760458"/>
                        <a:pt x="1898499" y="663333"/>
                      </a:cubicBezTo>
                      <a:cubicBezTo>
                        <a:pt x="1891392" y="566208"/>
                        <a:pt x="1873231" y="502247"/>
                        <a:pt x="1855859" y="445393"/>
                      </a:cubicBezTo>
                      <a:cubicBezTo>
                        <a:pt x="1838487" y="388539"/>
                        <a:pt x="1836118" y="365639"/>
                        <a:pt x="1794267" y="322209"/>
                      </a:cubicBezTo>
                      <a:cubicBezTo>
                        <a:pt x="1752416" y="278779"/>
                        <a:pt x="1697931" y="230612"/>
                        <a:pt x="1604754" y="184813"/>
                      </a:cubicBezTo>
                      <a:cubicBezTo>
                        <a:pt x="1511577" y="139014"/>
                        <a:pt x="1327591" y="75053"/>
                        <a:pt x="1235204" y="47416"/>
                      </a:cubicBezTo>
                      <a:cubicBezTo>
                        <a:pt x="1142817" y="19779"/>
                        <a:pt x="1106493" y="26886"/>
                        <a:pt x="1050429" y="18989"/>
                      </a:cubicBezTo>
                      <a:cubicBezTo>
                        <a:pt x="994365" y="11092"/>
                        <a:pt x="975414" y="-753"/>
                        <a:pt x="898819" y="37"/>
                      </a:cubicBezTo>
                      <a:cubicBezTo>
                        <a:pt x="822224" y="827"/>
                        <a:pt x="686406" y="38"/>
                        <a:pt x="590860" y="23727"/>
                      </a:cubicBezTo>
                      <a:cubicBezTo>
                        <a:pt x="495314" y="47416"/>
                        <a:pt x="406875" y="65577"/>
                        <a:pt x="325542" y="142172"/>
                      </a:cubicBezTo>
                      <a:cubicBezTo>
                        <a:pt x="244209" y="218767"/>
                        <a:pt x="156559" y="338002"/>
                        <a:pt x="102864" y="483295"/>
                      </a:cubicBezTo>
                      <a:cubicBezTo>
                        <a:pt x="49169" y="628588"/>
                        <a:pt x="-15581" y="838632"/>
                        <a:pt x="3370" y="1013932"/>
                      </a:cubicBezTo>
                      <a:cubicBezTo>
                        <a:pt x="22321" y="1189231"/>
                        <a:pt x="136819" y="1414277"/>
                        <a:pt x="216572" y="1535092"/>
                      </a:cubicBezTo>
                      <a:cubicBezTo>
                        <a:pt x="296325" y="1655906"/>
                        <a:pt x="410823" y="1690651"/>
                        <a:pt x="481890" y="1738819"/>
                      </a:cubicBezTo>
                      <a:cubicBezTo>
                        <a:pt x="552957" y="1786987"/>
                        <a:pt x="601915" y="1795673"/>
                        <a:pt x="680879" y="1814624"/>
                      </a:cubicBezTo>
                      <a:close/>
                    </a:path>
                  </a:pathLst>
                </a:custGeom>
                <a:noFill/>
                <a:ln>
                  <a:solidFill>
                    <a:srgbClr val="0070C0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8" name="フリーフォーム: 図形 37">
                  <a:extLst>
                    <a:ext uri="{FF2B5EF4-FFF2-40B4-BE49-F238E27FC236}">
                      <a16:creationId xmlns:a16="http://schemas.microsoft.com/office/drawing/2014/main" id="{A9B0EA81-0632-E369-BF3F-8BFBF98D8A6D}"/>
                    </a:ext>
                  </a:extLst>
                </p:cNvPr>
                <p:cNvSpPr/>
                <p:nvPr/>
              </p:nvSpPr>
              <p:spPr>
                <a:xfrm>
                  <a:off x="1382255" y="3942008"/>
                  <a:ext cx="2925159" cy="2138618"/>
                </a:xfrm>
                <a:custGeom>
                  <a:avLst/>
                  <a:gdLst>
                    <a:gd name="connsiteX0" fmla="*/ 2886524 w 2925159"/>
                    <a:gd name="connsiteY0" fmla="*/ 814767 h 2138618"/>
                    <a:gd name="connsiteX1" fmla="*/ 2668584 w 2925159"/>
                    <a:gd name="connsiteY1" fmla="*/ 577876 h 2138618"/>
                    <a:gd name="connsiteX2" fmla="*/ 2507498 w 2925159"/>
                    <a:gd name="connsiteY2" fmla="*/ 421528 h 2138618"/>
                    <a:gd name="connsiteX3" fmla="*/ 2289558 w 2925159"/>
                    <a:gd name="connsiteY3" fmla="*/ 236753 h 2138618"/>
                    <a:gd name="connsiteX4" fmla="*/ 2005289 w 2925159"/>
                    <a:gd name="connsiteY4" fmla="*/ 227277 h 2138618"/>
                    <a:gd name="connsiteX5" fmla="*/ 1702068 w 2925159"/>
                    <a:gd name="connsiteY5" fmla="*/ 184637 h 2138618"/>
                    <a:gd name="connsiteX6" fmla="*/ 1161956 w 2925159"/>
                    <a:gd name="connsiteY6" fmla="*/ 75667 h 2138618"/>
                    <a:gd name="connsiteX7" fmla="*/ 749766 w 2925159"/>
                    <a:gd name="connsiteY7" fmla="*/ 4599 h 2138618"/>
                    <a:gd name="connsiteX8" fmla="*/ 223867 w 2925159"/>
                    <a:gd name="connsiteY8" fmla="*/ 208326 h 2138618"/>
                    <a:gd name="connsiteX9" fmla="*/ 81733 w 2925159"/>
                    <a:gd name="connsiteY9" fmla="*/ 568400 h 2138618"/>
                    <a:gd name="connsiteX10" fmla="*/ 10665 w 2925159"/>
                    <a:gd name="connsiteY10" fmla="*/ 1146415 h 2138618"/>
                    <a:gd name="connsiteX11" fmla="*/ 20141 w 2925159"/>
                    <a:gd name="connsiteY11" fmla="*/ 1852351 h 2138618"/>
                    <a:gd name="connsiteX12" fmla="*/ 195440 w 2925159"/>
                    <a:gd name="connsiteY12" fmla="*/ 2103455 h 2138618"/>
                    <a:gd name="connsiteX13" fmla="*/ 683436 w 2925159"/>
                    <a:gd name="connsiteY13" fmla="*/ 2136620 h 2138618"/>
                    <a:gd name="connsiteX14" fmla="*/ 1782611 w 2925159"/>
                    <a:gd name="connsiteY14" fmla="*/ 2122407 h 2138618"/>
                    <a:gd name="connsiteX15" fmla="*/ 2521712 w 2925159"/>
                    <a:gd name="connsiteY15" fmla="*/ 1961320 h 2138618"/>
                    <a:gd name="connsiteX16" fmla="*/ 2862835 w 2925159"/>
                    <a:gd name="connsiteY16" fmla="*/ 1530179 h 2138618"/>
                    <a:gd name="connsiteX17" fmla="*/ 2919689 w 2925159"/>
                    <a:gd name="connsiteY17" fmla="*/ 1288550 h 2138618"/>
                    <a:gd name="connsiteX18" fmla="*/ 2919689 w 2925159"/>
                    <a:gd name="connsiteY18" fmla="*/ 1013756 h 2138618"/>
                    <a:gd name="connsiteX19" fmla="*/ 2886524 w 2925159"/>
                    <a:gd name="connsiteY19" fmla="*/ 814767 h 21386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2925159" h="2138618">
                      <a:moveTo>
                        <a:pt x="2886524" y="814767"/>
                      </a:moveTo>
                      <a:cubicBezTo>
                        <a:pt x="2844673" y="742120"/>
                        <a:pt x="2731755" y="643416"/>
                        <a:pt x="2668584" y="577876"/>
                      </a:cubicBezTo>
                      <a:cubicBezTo>
                        <a:pt x="2605413" y="512336"/>
                        <a:pt x="2570669" y="478382"/>
                        <a:pt x="2507498" y="421528"/>
                      </a:cubicBezTo>
                      <a:cubicBezTo>
                        <a:pt x="2444327" y="364674"/>
                        <a:pt x="2373259" y="269128"/>
                        <a:pt x="2289558" y="236753"/>
                      </a:cubicBezTo>
                      <a:cubicBezTo>
                        <a:pt x="2205857" y="204378"/>
                        <a:pt x="2103204" y="235963"/>
                        <a:pt x="2005289" y="227277"/>
                      </a:cubicBezTo>
                      <a:cubicBezTo>
                        <a:pt x="1907374" y="218591"/>
                        <a:pt x="1842623" y="209905"/>
                        <a:pt x="1702068" y="184637"/>
                      </a:cubicBezTo>
                      <a:cubicBezTo>
                        <a:pt x="1561512" y="159369"/>
                        <a:pt x="1161956" y="75667"/>
                        <a:pt x="1161956" y="75667"/>
                      </a:cubicBezTo>
                      <a:cubicBezTo>
                        <a:pt x="1003239" y="45661"/>
                        <a:pt x="906114" y="-17511"/>
                        <a:pt x="749766" y="4599"/>
                      </a:cubicBezTo>
                      <a:cubicBezTo>
                        <a:pt x="593418" y="26709"/>
                        <a:pt x="335206" y="114359"/>
                        <a:pt x="223867" y="208326"/>
                      </a:cubicBezTo>
                      <a:cubicBezTo>
                        <a:pt x="112528" y="302293"/>
                        <a:pt x="117267" y="412052"/>
                        <a:pt x="81733" y="568400"/>
                      </a:cubicBezTo>
                      <a:cubicBezTo>
                        <a:pt x="46199" y="724748"/>
                        <a:pt x="20930" y="932423"/>
                        <a:pt x="10665" y="1146415"/>
                      </a:cubicBezTo>
                      <a:cubicBezTo>
                        <a:pt x="400" y="1360407"/>
                        <a:pt x="-10655" y="1692844"/>
                        <a:pt x="20141" y="1852351"/>
                      </a:cubicBezTo>
                      <a:cubicBezTo>
                        <a:pt x="50937" y="2011858"/>
                        <a:pt x="84891" y="2056077"/>
                        <a:pt x="195440" y="2103455"/>
                      </a:cubicBezTo>
                      <a:cubicBezTo>
                        <a:pt x="305989" y="2150833"/>
                        <a:pt x="683436" y="2136620"/>
                        <a:pt x="683436" y="2136620"/>
                      </a:cubicBezTo>
                      <a:lnTo>
                        <a:pt x="1782611" y="2122407"/>
                      </a:lnTo>
                      <a:cubicBezTo>
                        <a:pt x="2088990" y="2093190"/>
                        <a:pt x="2341675" y="2060025"/>
                        <a:pt x="2521712" y="1961320"/>
                      </a:cubicBezTo>
                      <a:cubicBezTo>
                        <a:pt x="2701749" y="1862615"/>
                        <a:pt x="2796506" y="1642307"/>
                        <a:pt x="2862835" y="1530179"/>
                      </a:cubicBezTo>
                      <a:cubicBezTo>
                        <a:pt x="2929164" y="1418051"/>
                        <a:pt x="2910213" y="1374620"/>
                        <a:pt x="2919689" y="1288550"/>
                      </a:cubicBezTo>
                      <a:cubicBezTo>
                        <a:pt x="2929165" y="1202480"/>
                        <a:pt x="2924427" y="1090351"/>
                        <a:pt x="2919689" y="1013756"/>
                      </a:cubicBezTo>
                      <a:cubicBezTo>
                        <a:pt x="2914951" y="937161"/>
                        <a:pt x="2928375" y="887414"/>
                        <a:pt x="2886524" y="814767"/>
                      </a:cubicBezTo>
                      <a:close/>
                    </a:path>
                  </a:pathLst>
                </a:custGeom>
                <a:noFill/>
                <a:ln>
                  <a:solidFill>
                    <a:srgbClr val="0070C0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D630323F-7C3A-B17E-B0CE-B00B9731FD66}"/>
                    </a:ext>
                  </a:extLst>
                </p:cNvPr>
                <p:cNvSpPr txBox="1"/>
                <p:nvPr/>
              </p:nvSpPr>
              <p:spPr>
                <a:xfrm>
                  <a:off x="1379807" y="4504135"/>
                  <a:ext cx="743624" cy="2616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b="1" dirty="0"/>
                    <a:t>Cluster 2</a:t>
                  </a:r>
                  <a:endParaRPr kumimoji="1" lang="ja-JP" altLang="en-US" sz="1050" b="1" dirty="0"/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38448877-9143-FF3E-F3A1-D8269E93D380}"/>
                    </a:ext>
                  </a:extLst>
                </p:cNvPr>
                <p:cNvSpPr txBox="1"/>
                <p:nvPr/>
              </p:nvSpPr>
              <p:spPr>
                <a:xfrm>
                  <a:off x="7359453" y="3145208"/>
                  <a:ext cx="743624" cy="2616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b="1" dirty="0"/>
                    <a:t>Cluster 1</a:t>
                  </a:r>
                  <a:endParaRPr kumimoji="1" lang="ja-JP" altLang="en-US" sz="1050" b="1" dirty="0"/>
                </a:p>
              </p:txBody>
            </p:sp>
            <p:sp>
              <p:nvSpPr>
                <p:cNvPr id="43" name="フリーフォーム: 図形 42">
                  <a:extLst>
                    <a:ext uri="{FF2B5EF4-FFF2-40B4-BE49-F238E27FC236}">
                      <a16:creationId xmlns:a16="http://schemas.microsoft.com/office/drawing/2014/main" id="{C4EFF61D-0B83-D50B-07D0-E29D9D1415DC}"/>
                    </a:ext>
                  </a:extLst>
                </p:cNvPr>
                <p:cNvSpPr/>
                <p:nvPr/>
              </p:nvSpPr>
              <p:spPr>
                <a:xfrm>
                  <a:off x="6193767" y="4930671"/>
                  <a:ext cx="2044432" cy="1524118"/>
                </a:xfrm>
                <a:custGeom>
                  <a:avLst/>
                  <a:gdLst>
                    <a:gd name="connsiteX0" fmla="*/ 1453081 w 2044432"/>
                    <a:gd name="connsiteY0" fmla="*/ 10879 h 1524118"/>
                    <a:gd name="connsiteX1" fmla="*/ 1187763 w 2044432"/>
                    <a:gd name="connsiteY1" fmla="*/ 6141 h 1524118"/>
                    <a:gd name="connsiteX2" fmla="*/ 699767 w 2044432"/>
                    <a:gd name="connsiteY2" fmla="*/ 91422 h 1524118"/>
                    <a:gd name="connsiteX3" fmla="*/ 268625 w 2044432"/>
                    <a:gd name="connsiteY3" fmla="*/ 323576 h 1524118"/>
                    <a:gd name="connsiteX4" fmla="*/ 60160 w 2044432"/>
                    <a:gd name="connsiteY4" fmla="*/ 702602 h 1524118"/>
                    <a:gd name="connsiteX5" fmla="*/ 8044 w 2044432"/>
                    <a:gd name="connsiteY5" fmla="*/ 953706 h 1524118"/>
                    <a:gd name="connsiteX6" fmla="*/ 36471 w 2044432"/>
                    <a:gd name="connsiteY6" fmla="*/ 1237976 h 1524118"/>
                    <a:gd name="connsiteX7" fmla="*/ 339692 w 2044432"/>
                    <a:gd name="connsiteY7" fmla="*/ 1446440 h 1524118"/>
                    <a:gd name="connsiteX8" fmla="*/ 780310 w 2044432"/>
                    <a:gd name="connsiteY8" fmla="*/ 1522245 h 1524118"/>
                    <a:gd name="connsiteX9" fmla="*/ 1661545 w 2044432"/>
                    <a:gd name="connsiteY9" fmla="*/ 1380110 h 1524118"/>
                    <a:gd name="connsiteX10" fmla="*/ 2021620 w 2044432"/>
                    <a:gd name="connsiteY10" fmla="*/ 948968 h 1524118"/>
                    <a:gd name="connsiteX11" fmla="*/ 2007406 w 2044432"/>
                    <a:gd name="connsiteY11" fmla="*/ 584156 h 1524118"/>
                    <a:gd name="connsiteX12" fmla="*/ 2007406 w 2044432"/>
                    <a:gd name="connsiteY12" fmla="*/ 484662 h 1524118"/>
                    <a:gd name="connsiteX13" fmla="*/ 1827369 w 2044432"/>
                    <a:gd name="connsiteY13" fmla="*/ 176703 h 1524118"/>
                    <a:gd name="connsiteX14" fmla="*/ 1614167 w 2044432"/>
                    <a:gd name="connsiteY14" fmla="*/ 44044 h 1524118"/>
                    <a:gd name="connsiteX15" fmla="*/ 1453081 w 2044432"/>
                    <a:gd name="connsiteY15" fmla="*/ 10879 h 15241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</a:cxnLst>
                  <a:rect l="l" t="t" r="r" b="b"/>
                  <a:pathLst>
                    <a:path w="2044432" h="1524118">
                      <a:moveTo>
                        <a:pt x="1453081" y="10879"/>
                      </a:moveTo>
                      <a:cubicBezTo>
                        <a:pt x="1382014" y="4562"/>
                        <a:pt x="1313315" y="-7283"/>
                        <a:pt x="1187763" y="6141"/>
                      </a:cubicBezTo>
                      <a:cubicBezTo>
                        <a:pt x="1062211" y="19565"/>
                        <a:pt x="852957" y="38516"/>
                        <a:pt x="699767" y="91422"/>
                      </a:cubicBezTo>
                      <a:cubicBezTo>
                        <a:pt x="546577" y="144328"/>
                        <a:pt x="375226" y="221713"/>
                        <a:pt x="268625" y="323576"/>
                      </a:cubicBezTo>
                      <a:cubicBezTo>
                        <a:pt x="162024" y="425439"/>
                        <a:pt x="103590" y="597580"/>
                        <a:pt x="60160" y="702602"/>
                      </a:cubicBezTo>
                      <a:cubicBezTo>
                        <a:pt x="16730" y="807624"/>
                        <a:pt x="11992" y="864477"/>
                        <a:pt x="8044" y="953706"/>
                      </a:cubicBezTo>
                      <a:cubicBezTo>
                        <a:pt x="4096" y="1042935"/>
                        <a:pt x="-18804" y="1155854"/>
                        <a:pt x="36471" y="1237976"/>
                      </a:cubicBezTo>
                      <a:cubicBezTo>
                        <a:pt x="91746" y="1320098"/>
                        <a:pt x="215719" y="1399062"/>
                        <a:pt x="339692" y="1446440"/>
                      </a:cubicBezTo>
                      <a:cubicBezTo>
                        <a:pt x="463665" y="1493818"/>
                        <a:pt x="560001" y="1533300"/>
                        <a:pt x="780310" y="1522245"/>
                      </a:cubicBezTo>
                      <a:cubicBezTo>
                        <a:pt x="1000619" y="1511190"/>
                        <a:pt x="1454660" y="1475656"/>
                        <a:pt x="1661545" y="1380110"/>
                      </a:cubicBezTo>
                      <a:cubicBezTo>
                        <a:pt x="1868430" y="1284564"/>
                        <a:pt x="1963977" y="1081627"/>
                        <a:pt x="2021620" y="948968"/>
                      </a:cubicBezTo>
                      <a:cubicBezTo>
                        <a:pt x="2079264" y="816309"/>
                        <a:pt x="2009775" y="661540"/>
                        <a:pt x="2007406" y="584156"/>
                      </a:cubicBezTo>
                      <a:cubicBezTo>
                        <a:pt x="2005037" y="506772"/>
                        <a:pt x="2037412" y="552571"/>
                        <a:pt x="2007406" y="484662"/>
                      </a:cubicBezTo>
                      <a:cubicBezTo>
                        <a:pt x="1977400" y="416753"/>
                        <a:pt x="1892909" y="250139"/>
                        <a:pt x="1827369" y="176703"/>
                      </a:cubicBezTo>
                      <a:cubicBezTo>
                        <a:pt x="1761829" y="103267"/>
                        <a:pt x="1671021" y="68523"/>
                        <a:pt x="1614167" y="44044"/>
                      </a:cubicBezTo>
                      <a:cubicBezTo>
                        <a:pt x="1557313" y="19565"/>
                        <a:pt x="1524148" y="17196"/>
                        <a:pt x="1453081" y="10879"/>
                      </a:cubicBezTo>
                      <a:close/>
                    </a:path>
                  </a:pathLst>
                </a:custGeom>
                <a:noFill/>
                <a:ln>
                  <a:solidFill>
                    <a:srgbClr val="0070C0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1ACE4BBD-91EA-6592-8E58-5E3F1EF33830}"/>
                    </a:ext>
                  </a:extLst>
                </p:cNvPr>
                <p:cNvSpPr txBox="1"/>
                <p:nvPr/>
              </p:nvSpPr>
              <p:spPr>
                <a:xfrm>
                  <a:off x="7735797" y="4717462"/>
                  <a:ext cx="743624" cy="26161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50" b="1" dirty="0"/>
                    <a:t>Cluster 4</a:t>
                  </a:r>
                  <a:endParaRPr kumimoji="1" lang="ja-JP" altLang="en-US" sz="1050" b="1" dirty="0"/>
                </a:p>
              </p:txBody>
            </p:sp>
            <p:sp>
              <p:nvSpPr>
                <p:cNvPr id="45" name="フリーフォーム: 図形 44">
                  <a:extLst>
                    <a:ext uri="{FF2B5EF4-FFF2-40B4-BE49-F238E27FC236}">
                      <a16:creationId xmlns:a16="http://schemas.microsoft.com/office/drawing/2014/main" id="{958795D2-B4ED-8D70-8A7A-2CA3903E5830}"/>
                    </a:ext>
                  </a:extLst>
                </p:cNvPr>
                <p:cNvSpPr/>
                <p:nvPr/>
              </p:nvSpPr>
              <p:spPr>
                <a:xfrm>
                  <a:off x="3299402" y="3345"/>
                  <a:ext cx="2018884" cy="2422702"/>
                </a:xfrm>
                <a:custGeom>
                  <a:avLst/>
                  <a:gdLst>
                    <a:gd name="connsiteX0" fmla="*/ 1248909 w 2018884"/>
                    <a:gd name="connsiteY0" fmla="*/ 1393 h 2422702"/>
                    <a:gd name="connsiteX1" fmla="*/ 865145 w 2018884"/>
                    <a:gd name="connsiteY1" fmla="*/ 77198 h 2422702"/>
                    <a:gd name="connsiteX2" fmla="*/ 429265 w 2018884"/>
                    <a:gd name="connsiteY2" fmla="*/ 337778 h 2422702"/>
                    <a:gd name="connsiteX3" fmla="*/ 135520 w 2018884"/>
                    <a:gd name="connsiteY3" fmla="*/ 844725 h 2422702"/>
                    <a:gd name="connsiteX4" fmla="*/ 26550 w 2018884"/>
                    <a:gd name="connsiteY4" fmla="*/ 1560137 h 2422702"/>
                    <a:gd name="connsiteX5" fmla="*/ 7599 w 2018884"/>
                    <a:gd name="connsiteY5" fmla="*/ 2057608 h 2422702"/>
                    <a:gd name="connsiteX6" fmla="*/ 130782 w 2018884"/>
                    <a:gd name="connsiteY6" fmla="*/ 2327664 h 2422702"/>
                    <a:gd name="connsiteX7" fmla="*/ 358198 w 2018884"/>
                    <a:gd name="connsiteY7" fmla="*/ 2422421 h 2422702"/>
                    <a:gd name="connsiteX8" fmla="*/ 642467 w 2018884"/>
                    <a:gd name="connsiteY8" fmla="*/ 2303975 h 2422702"/>
                    <a:gd name="connsiteX9" fmla="*/ 874621 w 2018884"/>
                    <a:gd name="connsiteY9" fmla="*/ 2285024 h 2422702"/>
                    <a:gd name="connsiteX10" fmla="*/ 1310501 w 2018884"/>
                    <a:gd name="connsiteY10" fmla="*/ 2071822 h 2422702"/>
                    <a:gd name="connsiteX11" fmla="*/ 1713216 w 2018884"/>
                    <a:gd name="connsiteY11" fmla="*/ 1493807 h 2422702"/>
                    <a:gd name="connsiteX12" fmla="*/ 1940631 w 2018884"/>
                    <a:gd name="connsiteY12" fmla="*/ 1057928 h 2422702"/>
                    <a:gd name="connsiteX13" fmla="*/ 2016436 w 2018884"/>
                    <a:gd name="connsiteY13" fmla="*/ 645737 h 2422702"/>
                    <a:gd name="connsiteX14" fmla="*/ 1864826 w 2018884"/>
                    <a:gd name="connsiteY14" fmla="*/ 233546 h 2422702"/>
                    <a:gd name="connsiteX15" fmla="*/ 1575819 w 2018884"/>
                    <a:gd name="connsiteY15" fmla="*/ 44033 h 2422702"/>
                    <a:gd name="connsiteX16" fmla="*/ 1248909 w 2018884"/>
                    <a:gd name="connsiteY16" fmla="*/ 1393 h 242270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2018884" h="2422702">
                      <a:moveTo>
                        <a:pt x="1248909" y="1393"/>
                      </a:moveTo>
                      <a:cubicBezTo>
                        <a:pt x="1130463" y="6921"/>
                        <a:pt x="1001752" y="21134"/>
                        <a:pt x="865145" y="77198"/>
                      </a:cubicBezTo>
                      <a:cubicBezTo>
                        <a:pt x="728538" y="133262"/>
                        <a:pt x="550869" y="209857"/>
                        <a:pt x="429265" y="337778"/>
                      </a:cubicBezTo>
                      <a:cubicBezTo>
                        <a:pt x="307661" y="465699"/>
                        <a:pt x="202639" y="640998"/>
                        <a:pt x="135520" y="844725"/>
                      </a:cubicBezTo>
                      <a:cubicBezTo>
                        <a:pt x="68401" y="1048452"/>
                        <a:pt x="47870" y="1357990"/>
                        <a:pt x="26550" y="1560137"/>
                      </a:cubicBezTo>
                      <a:cubicBezTo>
                        <a:pt x="5230" y="1762284"/>
                        <a:pt x="-9773" y="1929687"/>
                        <a:pt x="7599" y="2057608"/>
                      </a:cubicBezTo>
                      <a:cubicBezTo>
                        <a:pt x="24971" y="2185529"/>
                        <a:pt x="72349" y="2266862"/>
                        <a:pt x="130782" y="2327664"/>
                      </a:cubicBezTo>
                      <a:cubicBezTo>
                        <a:pt x="189215" y="2388466"/>
                        <a:pt x="272917" y="2426369"/>
                        <a:pt x="358198" y="2422421"/>
                      </a:cubicBezTo>
                      <a:cubicBezTo>
                        <a:pt x="443479" y="2418473"/>
                        <a:pt x="556396" y="2326875"/>
                        <a:pt x="642467" y="2303975"/>
                      </a:cubicBezTo>
                      <a:cubicBezTo>
                        <a:pt x="728538" y="2281075"/>
                        <a:pt x="763282" y="2323716"/>
                        <a:pt x="874621" y="2285024"/>
                      </a:cubicBezTo>
                      <a:cubicBezTo>
                        <a:pt x="985960" y="2246332"/>
                        <a:pt x="1170735" y="2203691"/>
                        <a:pt x="1310501" y="2071822"/>
                      </a:cubicBezTo>
                      <a:cubicBezTo>
                        <a:pt x="1450267" y="1939953"/>
                        <a:pt x="1608194" y="1662789"/>
                        <a:pt x="1713216" y="1493807"/>
                      </a:cubicBezTo>
                      <a:cubicBezTo>
                        <a:pt x="1818238" y="1324825"/>
                        <a:pt x="1890094" y="1199273"/>
                        <a:pt x="1940631" y="1057928"/>
                      </a:cubicBezTo>
                      <a:cubicBezTo>
                        <a:pt x="1991168" y="916583"/>
                        <a:pt x="2029070" y="783134"/>
                        <a:pt x="2016436" y="645737"/>
                      </a:cubicBezTo>
                      <a:cubicBezTo>
                        <a:pt x="2003802" y="508340"/>
                        <a:pt x="1938262" y="333830"/>
                        <a:pt x="1864826" y="233546"/>
                      </a:cubicBezTo>
                      <a:cubicBezTo>
                        <a:pt x="1791390" y="133262"/>
                        <a:pt x="1675313" y="81935"/>
                        <a:pt x="1575819" y="44033"/>
                      </a:cubicBezTo>
                      <a:cubicBezTo>
                        <a:pt x="1476325" y="6131"/>
                        <a:pt x="1367355" y="-4135"/>
                        <a:pt x="1248909" y="1393"/>
                      </a:cubicBezTo>
                      <a:close/>
                    </a:path>
                  </a:pathLst>
                </a:custGeom>
                <a:noFill/>
                <a:ln>
                  <a:solidFill>
                    <a:srgbClr val="0070C0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5" name="フリーフォーム: 図形 54">
                  <a:extLst>
                    <a:ext uri="{FF2B5EF4-FFF2-40B4-BE49-F238E27FC236}">
                      <a16:creationId xmlns:a16="http://schemas.microsoft.com/office/drawing/2014/main" id="{BE286040-E065-801B-DB26-D2A61D160A72}"/>
                    </a:ext>
                  </a:extLst>
                </p:cNvPr>
                <p:cNvSpPr/>
                <p:nvPr/>
              </p:nvSpPr>
              <p:spPr>
                <a:xfrm>
                  <a:off x="5368746" y="86149"/>
                  <a:ext cx="2385150" cy="3010845"/>
                </a:xfrm>
                <a:custGeom>
                  <a:avLst/>
                  <a:gdLst>
                    <a:gd name="connsiteX0" fmla="*/ 899395 w 2385150"/>
                    <a:gd name="connsiteY0" fmla="*/ 32297 h 3010845"/>
                    <a:gd name="connsiteX1" fmla="*/ 681455 w 2385150"/>
                    <a:gd name="connsiteY1" fmla="*/ 41772 h 3010845"/>
                    <a:gd name="connsiteX2" fmla="*/ 169770 w 2385150"/>
                    <a:gd name="connsiteY2" fmla="*/ 198120 h 3010845"/>
                    <a:gd name="connsiteX3" fmla="*/ 3946 w 2385150"/>
                    <a:gd name="connsiteY3" fmla="*/ 482390 h 3010845"/>
                    <a:gd name="connsiteX4" fmla="*/ 60800 w 2385150"/>
                    <a:gd name="connsiteY4" fmla="*/ 960910 h 3010845"/>
                    <a:gd name="connsiteX5" fmla="*/ 160294 w 2385150"/>
                    <a:gd name="connsiteY5" fmla="*/ 1439430 h 3010845"/>
                    <a:gd name="connsiteX6" fmla="*/ 292953 w 2385150"/>
                    <a:gd name="connsiteY6" fmla="*/ 1775816 h 3010845"/>
                    <a:gd name="connsiteX7" fmla="*/ 638815 w 2385150"/>
                    <a:gd name="connsiteY7" fmla="*/ 2254336 h 3010845"/>
                    <a:gd name="connsiteX8" fmla="*/ 956249 w 2385150"/>
                    <a:gd name="connsiteY8" fmla="*/ 2694954 h 3010845"/>
                    <a:gd name="connsiteX9" fmla="*/ 1126810 w 2385150"/>
                    <a:gd name="connsiteY9" fmla="*/ 2822875 h 3010845"/>
                    <a:gd name="connsiteX10" fmla="*/ 1444245 w 2385150"/>
                    <a:gd name="connsiteY10" fmla="*/ 2998174 h 3010845"/>
                    <a:gd name="connsiteX11" fmla="*/ 1946454 w 2385150"/>
                    <a:gd name="connsiteY11" fmla="*/ 2965010 h 3010845"/>
                    <a:gd name="connsiteX12" fmla="*/ 2263888 w 2385150"/>
                    <a:gd name="connsiteY12" fmla="*/ 2709167 h 3010845"/>
                    <a:gd name="connsiteX13" fmla="*/ 2377596 w 2385150"/>
                    <a:gd name="connsiteY13" fmla="*/ 2240123 h 3010845"/>
                    <a:gd name="connsiteX14" fmla="*/ 2363382 w 2385150"/>
                    <a:gd name="connsiteY14" fmla="*/ 1501022 h 3010845"/>
                    <a:gd name="connsiteX15" fmla="*/ 2273364 w 2385150"/>
                    <a:gd name="connsiteY15" fmla="*/ 600835 h 3010845"/>
                    <a:gd name="connsiteX16" fmla="*/ 2140705 w 2385150"/>
                    <a:gd name="connsiteY16" fmla="*/ 330779 h 3010845"/>
                    <a:gd name="connsiteX17" fmla="*/ 1837484 w 2385150"/>
                    <a:gd name="connsiteY17" fmla="*/ 108102 h 3010845"/>
                    <a:gd name="connsiteX18" fmla="*/ 1349488 w 2385150"/>
                    <a:gd name="connsiteY18" fmla="*/ 3870 h 3010845"/>
                    <a:gd name="connsiteX19" fmla="*/ 837803 w 2385150"/>
                    <a:gd name="connsiteY19" fmla="*/ 22821 h 3010845"/>
                    <a:gd name="connsiteX20" fmla="*/ 899395 w 2385150"/>
                    <a:gd name="connsiteY20" fmla="*/ 32297 h 301084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</a:cxnLst>
                  <a:rect l="l" t="t" r="r" b="b"/>
                  <a:pathLst>
                    <a:path w="2385150" h="3010845">
                      <a:moveTo>
                        <a:pt x="899395" y="32297"/>
                      </a:moveTo>
                      <a:cubicBezTo>
                        <a:pt x="873337" y="35456"/>
                        <a:pt x="803059" y="14135"/>
                        <a:pt x="681455" y="41772"/>
                      </a:cubicBezTo>
                      <a:cubicBezTo>
                        <a:pt x="559851" y="69409"/>
                        <a:pt x="282688" y="124684"/>
                        <a:pt x="169770" y="198120"/>
                      </a:cubicBezTo>
                      <a:cubicBezTo>
                        <a:pt x="56852" y="271556"/>
                        <a:pt x="22108" y="355258"/>
                        <a:pt x="3946" y="482390"/>
                      </a:cubicBezTo>
                      <a:cubicBezTo>
                        <a:pt x="-14216" y="609522"/>
                        <a:pt x="34742" y="801403"/>
                        <a:pt x="60800" y="960910"/>
                      </a:cubicBezTo>
                      <a:cubicBezTo>
                        <a:pt x="86858" y="1120417"/>
                        <a:pt x="121602" y="1303612"/>
                        <a:pt x="160294" y="1439430"/>
                      </a:cubicBezTo>
                      <a:cubicBezTo>
                        <a:pt x="198986" y="1575248"/>
                        <a:pt x="213200" y="1639998"/>
                        <a:pt x="292953" y="1775816"/>
                      </a:cubicBezTo>
                      <a:cubicBezTo>
                        <a:pt x="372706" y="1911634"/>
                        <a:pt x="638815" y="2254336"/>
                        <a:pt x="638815" y="2254336"/>
                      </a:cubicBezTo>
                      <a:cubicBezTo>
                        <a:pt x="749364" y="2407526"/>
                        <a:pt x="874916" y="2600197"/>
                        <a:pt x="956249" y="2694954"/>
                      </a:cubicBezTo>
                      <a:cubicBezTo>
                        <a:pt x="1037582" y="2789711"/>
                        <a:pt x="1045477" y="2772338"/>
                        <a:pt x="1126810" y="2822875"/>
                      </a:cubicBezTo>
                      <a:cubicBezTo>
                        <a:pt x="1208143" y="2873412"/>
                        <a:pt x="1307638" y="2974485"/>
                        <a:pt x="1444245" y="2998174"/>
                      </a:cubicBezTo>
                      <a:cubicBezTo>
                        <a:pt x="1580852" y="3021863"/>
                        <a:pt x="1809847" y="3013178"/>
                        <a:pt x="1946454" y="2965010"/>
                      </a:cubicBezTo>
                      <a:cubicBezTo>
                        <a:pt x="2083061" y="2916842"/>
                        <a:pt x="2192031" y="2829981"/>
                        <a:pt x="2263888" y="2709167"/>
                      </a:cubicBezTo>
                      <a:cubicBezTo>
                        <a:pt x="2335745" y="2588353"/>
                        <a:pt x="2361014" y="2441480"/>
                        <a:pt x="2377596" y="2240123"/>
                      </a:cubicBezTo>
                      <a:cubicBezTo>
                        <a:pt x="2394178" y="2038766"/>
                        <a:pt x="2380754" y="1774237"/>
                        <a:pt x="2363382" y="1501022"/>
                      </a:cubicBezTo>
                      <a:cubicBezTo>
                        <a:pt x="2346010" y="1227807"/>
                        <a:pt x="2310477" y="795876"/>
                        <a:pt x="2273364" y="600835"/>
                      </a:cubicBezTo>
                      <a:cubicBezTo>
                        <a:pt x="2236251" y="405795"/>
                        <a:pt x="2213352" y="412901"/>
                        <a:pt x="2140705" y="330779"/>
                      </a:cubicBezTo>
                      <a:cubicBezTo>
                        <a:pt x="2068058" y="248657"/>
                        <a:pt x="1969354" y="162587"/>
                        <a:pt x="1837484" y="108102"/>
                      </a:cubicBezTo>
                      <a:cubicBezTo>
                        <a:pt x="1705615" y="53617"/>
                        <a:pt x="1516101" y="18083"/>
                        <a:pt x="1349488" y="3870"/>
                      </a:cubicBezTo>
                      <a:cubicBezTo>
                        <a:pt x="1182875" y="-10343"/>
                        <a:pt x="920715" y="18873"/>
                        <a:pt x="837803" y="22821"/>
                      </a:cubicBezTo>
                      <a:cubicBezTo>
                        <a:pt x="754891" y="26769"/>
                        <a:pt x="925453" y="29138"/>
                        <a:pt x="899395" y="32297"/>
                      </a:cubicBezTo>
                      <a:close/>
                    </a:path>
                  </a:pathLst>
                </a:custGeom>
                <a:noFill/>
                <a:ln>
                  <a:solidFill>
                    <a:srgbClr val="0070C0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6" name="フリーフォーム: 図形 55">
                  <a:extLst>
                    <a:ext uri="{FF2B5EF4-FFF2-40B4-BE49-F238E27FC236}">
                      <a16:creationId xmlns:a16="http://schemas.microsoft.com/office/drawing/2014/main" id="{B12A9614-81A7-43A6-06F2-B680082EBBAE}"/>
                    </a:ext>
                  </a:extLst>
                </p:cNvPr>
                <p:cNvSpPr/>
                <p:nvPr/>
              </p:nvSpPr>
              <p:spPr>
                <a:xfrm>
                  <a:off x="3793427" y="2314332"/>
                  <a:ext cx="1603010" cy="2491423"/>
                </a:xfrm>
                <a:custGeom>
                  <a:avLst/>
                  <a:gdLst>
                    <a:gd name="connsiteX0" fmla="*/ 6308 w 1603010"/>
                    <a:gd name="connsiteY0" fmla="*/ 149336 h 2491423"/>
                    <a:gd name="connsiteX1" fmla="*/ 53686 w 1603010"/>
                    <a:gd name="connsiteY1" fmla="*/ 457295 h 2491423"/>
                    <a:gd name="connsiteX2" fmla="*/ 247937 w 1603010"/>
                    <a:gd name="connsiteY2" fmla="*/ 760516 h 2491423"/>
                    <a:gd name="connsiteX3" fmla="*/ 352169 w 1603010"/>
                    <a:gd name="connsiteY3" fmla="*/ 1106377 h 2491423"/>
                    <a:gd name="connsiteX4" fmla="*/ 427974 w 1603010"/>
                    <a:gd name="connsiteY4" fmla="*/ 1456976 h 2491423"/>
                    <a:gd name="connsiteX5" fmla="*/ 423236 w 1603010"/>
                    <a:gd name="connsiteY5" fmla="*/ 2053942 h 2491423"/>
                    <a:gd name="connsiteX6" fmla="*/ 541682 w 1603010"/>
                    <a:gd name="connsiteY6" fmla="*/ 2437705 h 2491423"/>
                    <a:gd name="connsiteX7" fmla="*/ 674341 w 1603010"/>
                    <a:gd name="connsiteY7" fmla="*/ 2461394 h 2491423"/>
                    <a:gd name="connsiteX8" fmla="*/ 830689 w 1603010"/>
                    <a:gd name="connsiteY8" fmla="*/ 2181863 h 2491423"/>
                    <a:gd name="connsiteX9" fmla="*/ 1299734 w 1603010"/>
                    <a:gd name="connsiteY9" fmla="*/ 2091844 h 2491423"/>
                    <a:gd name="connsiteX10" fmla="*/ 1593479 w 1603010"/>
                    <a:gd name="connsiteY10" fmla="*/ 1480665 h 2491423"/>
                    <a:gd name="connsiteX11" fmla="*/ 1484509 w 1603010"/>
                    <a:gd name="connsiteY11" fmla="*/ 1049523 h 2491423"/>
                    <a:gd name="connsiteX12" fmla="*/ 1029678 w 1603010"/>
                    <a:gd name="connsiteY12" fmla="*/ 774729 h 2491423"/>
                    <a:gd name="connsiteX13" fmla="*/ 731195 w 1603010"/>
                    <a:gd name="connsiteY13" fmla="*/ 452557 h 2491423"/>
                    <a:gd name="connsiteX14" fmla="*/ 688554 w 1603010"/>
                    <a:gd name="connsiteY14" fmla="*/ 187239 h 2491423"/>
                    <a:gd name="connsiteX15" fmla="*/ 413761 w 1603010"/>
                    <a:gd name="connsiteY15" fmla="*/ 26153 h 2491423"/>
                    <a:gd name="connsiteX16" fmla="*/ 167394 w 1603010"/>
                    <a:gd name="connsiteY16" fmla="*/ 11940 h 2491423"/>
                    <a:gd name="connsiteX17" fmla="*/ 6308 w 1603010"/>
                    <a:gd name="connsiteY17" fmla="*/ 149336 h 249142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</a:cxnLst>
                  <a:rect l="l" t="t" r="r" b="b"/>
                  <a:pathLst>
                    <a:path w="1603010" h="2491423">
                      <a:moveTo>
                        <a:pt x="6308" y="149336"/>
                      </a:moveTo>
                      <a:cubicBezTo>
                        <a:pt x="-12643" y="223562"/>
                        <a:pt x="13415" y="355432"/>
                        <a:pt x="53686" y="457295"/>
                      </a:cubicBezTo>
                      <a:cubicBezTo>
                        <a:pt x="93958" y="559158"/>
                        <a:pt x="198190" y="652336"/>
                        <a:pt x="247937" y="760516"/>
                      </a:cubicBezTo>
                      <a:cubicBezTo>
                        <a:pt x="297684" y="868696"/>
                        <a:pt x="322163" y="990300"/>
                        <a:pt x="352169" y="1106377"/>
                      </a:cubicBezTo>
                      <a:cubicBezTo>
                        <a:pt x="382175" y="1222454"/>
                        <a:pt x="416130" y="1299049"/>
                        <a:pt x="427974" y="1456976"/>
                      </a:cubicBezTo>
                      <a:cubicBezTo>
                        <a:pt x="439818" y="1614903"/>
                        <a:pt x="404285" y="1890487"/>
                        <a:pt x="423236" y="2053942"/>
                      </a:cubicBezTo>
                      <a:cubicBezTo>
                        <a:pt x="442187" y="2217397"/>
                        <a:pt x="499831" y="2369796"/>
                        <a:pt x="541682" y="2437705"/>
                      </a:cubicBezTo>
                      <a:cubicBezTo>
                        <a:pt x="583533" y="2505614"/>
                        <a:pt x="626173" y="2504034"/>
                        <a:pt x="674341" y="2461394"/>
                      </a:cubicBezTo>
                      <a:cubicBezTo>
                        <a:pt x="722509" y="2418754"/>
                        <a:pt x="726457" y="2243455"/>
                        <a:pt x="830689" y="2181863"/>
                      </a:cubicBezTo>
                      <a:cubicBezTo>
                        <a:pt x="934921" y="2120271"/>
                        <a:pt x="1172602" y="2208710"/>
                        <a:pt x="1299734" y="2091844"/>
                      </a:cubicBezTo>
                      <a:cubicBezTo>
                        <a:pt x="1426866" y="1974978"/>
                        <a:pt x="1562683" y="1654385"/>
                        <a:pt x="1593479" y="1480665"/>
                      </a:cubicBezTo>
                      <a:cubicBezTo>
                        <a:pt x="1624275" y="1306945"/>
                        <a:pt x="1578476" y="1167179"/>
                        <a:pt x="1484509" y="1049523"/>
                      </a:cubicBezTo>
                      <a:cubicBezTo>
                        <a:pt x="1390542" y="931867"/>
                        <a:pt x="1155230" y="874223"/>
                        <a:pt x="1029678" y="774729"/>
                      </a:cubicBezTo>
                      <a:cubicBezTo>
                        <a:pt x="904126" y="675235"/>
                        <a:pt x="788049" y="550472"/>
                        <a:pt x="731195" y="452557"/>
                      </a:cubicBezTo>
                      <a:cubicBezTo>
                        <a:pt x="674341" y="354642"/>
                        <a:pt x="741460" y="258306"/>
                        <a:pt x="688554" y="187239"/>
                      </a:cubicBezTo>
                      <a:cubicBezTo>
                        <a:pt x="635648" y="116172"/>
                        <a:pt x="500621" y="55369"/>
                        <a:pt x="413761" y="26153"/>
                      </a:cubicBezTo>
                      <a:cubicBezTo>
                        <a:pt x="326901" y="-3063"/>
                        <a:pt x="238462" y="-7801"/>
                        <a:pt x="167394" y="11940"/>
                      </a:cubicBezTo>
                      <a:cubicBezTo>
                        <a:pt x="96326" y="31681"/>
                        <a:pt x="25259" y="75110"/>
                        <a:pt x="6308" y="149336"/>
                      </a:cubicBezTo>
                      <a:close/>
                    </a:path>
                  </a:pathLst>
                </a:custGeom>
                <a:noFill/>
                <a:ln w="19050">
                  <a:solidFill>
                    <a:srgbClr val="7030A0"/>
                  </a:solidFill>
                  <a:prstDash val="solid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" name="正方形/長方形 4">
                  <a:extLst>
                    <a:ext uri="{FF2B5EF4-FFF2-40B4-BE49-F238E27FC236}">
                      <a16:creationId xmlns:a16="http://schemas.microsoft.com/office/drawing/2014/main" id="{EB50E5CE-691B-2F2C-37CF-4ADB8C2E1E19}"/>
                    </a:ext>
                  </a:extLst>
                </p:cNvPr>
                <p:cNvSpPr/>
                <p:nvPr/>
              </p:nvSpPr>
              <p:spPr>
                <a:xfrm>
                  <a:off x="4951981" y="2807971"/>
                  <a:ext cx="245454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5" name="正方形/長方形 14">
                  <a:extLst>
                    <a:ext uri="{FF2B5EF4-FFF2-40B4-BE49-F238E27FC236}">
                      <a16:creationId xmlns:a16="http://schemas.microsoft.com/office/drawing/2014/main" id="{770A290E-A6B8-9E84-F026-80893412D75B}"/>
                    </a:ext>
                  </a:extLst>
                </p:cNvPr>
                <p:cNvSpPr/>
                <p:nvPr/>
              </p:nvSpPr>
              <p:spPr>
                <a:xfrm>
                  <a:off x="5176074" y="4734074"/>
                  <a:ext cx="254255" cy="105508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" name="正方形/長方形 21">
                  <a:extLst>
                    <a:ext uri="{FF2B5EF4-FFF2-40B4-BE49-F238E27FC236}">
                      <a16:creationId xmlns:a16="http://schemas.microsoft.com/office/drawing/2014/main" id="{30E69D12-FDF1-1B6D-AF27-1568D44C62EB}"/>
                    </a:ext>
                  </a:extLst>
                </p:cNvPr>
                <p:cNvSpPr/>
                <p:nvPr/>
              </p:nvSpPr>
              <p:spPr>
                <a:xfrm>
                  <a:off x="5421088" y="4805340"/>
                  <a:ext cx="254255" cy="105508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" name="フリーフォーム: 図形 22">
                  <a:extLst>
                    <a:ext uri="{FF2B5EF4-FFF2-40B4-BE49-F238E27FC236}">
                      <a16:creationId xmlns:a16="http://schemas.microsoft.com/office/drawing/2014/main" id="{4AEC6EF3-C7D1-2F7B-FEB0-37F2C1748010}"/>
                    </a:ext>
                  </a:extLst>
                </p:cNvPr>
                <p:cNvSpPr/>
                <p:nvPr/>
              </p:nvSpPr>
              <p:spPr>
                <a:xfrm>
                  <a:off x="3790703" y="1522438"/>
                  <a:ext cx="2534585" cy="4951352"/>
                </a:xfrm>
                <a:custGeom>
                  <a:avLst/>
                  <a:gdLst>
                    <a:gd name="connsiteX0" fmla="*/ 900872 w 2534585"/>
                    <a:gd name="connsiteY0" fmla="*/ 4336756 h 4951352"/>
                    <a:gd name="connsiteX1" fmla="*/ 633586 w 2534585"/>
                    <a:gd name="connsiteY1" fmla="*/ 3935827 h 4951352"/>
                    <a:gd name="connsiteX2" fmla="*/ 626552 w 2534585"/>
                    <a:gd name="connsiteY2" fmla="*/ 3499728 h 4951352"/>
                    <a:gd name="connsiteX3" fmla="*/ 499943 w 2534585"/>
                    <a:gd name="connsiteY3" fmla="*/ 3049562 h 4951352"/>
                    <a:gd name="connsiteX4" fmla="*/ 415537 w 2534585"/>
                    <a:gd name="connsiteY4" fmla="*/ 2486854 h 4951352"/>
                    <a:gd name="connsiteX5" fmla="*/ 274860 w 2534585"/>
                    <a:gd name="connsiteY5" fmla="*/ 1699064 h 4951352"/>
                    <a:gd name="connsiteX6" fmla="*/ 84946 w 2534585"/>
                    <a:gd name="connsiteY6" fmla="*/ 1262965 h 4951352"/>
                    <a:gd name="connsiteX7" fmla="*/ 7574 w 2534585"/>
                    <a:gd name="connsiteY7" fmla="*/ 876104 h 4951352"/>
                    <a:gd name="connsiteX8" fmla="*/ 260792 w 2534585"/>
                    <a:gd name="connsiteY8" fmla="*/ 784664 h 4951352"/>
                    <a:gd name="connsiteX9" fmla="*/ 725026 w 2534585"/>
                    <a:gd name="connsiteY9" fmla="*/ 643987 h 4951352"/>
                    <a:gd name="connsiteX10" fmla="*/ 1041549 w 2534585"/>
                    <a:gd name="connsiteY10" fmla="*/ 327464 h 4951352"/>
                    <a:gd name="connsiteX11" fmla="*/ 1196294 w 2534585"/>
                    <a:gd name="connsiteY11" fmla="*/ 81279 h 4951352"/>
                    <a:gd name="connsiteX12" fmla="*/ 1646460 w 2534585"/>
                    <a:gd name="connsiteY12" fmla="*/ 46110 h 4951352"/>
                    <a:gd name="connsiteX13" fmla="*/ 2068491 w 2534585"/>
                    <a:gd name="connsiteY13" fmla="*/ 686190 h 4951352"/>
                    <a:gd name="connsiteX14" fmla="*/ 2483488 w 2534585"/>
                    <a:gd name="connsiteY14" fmla="*/ 1213728 h 4951352"/>
                    <a:gd name="connsiteX15" fmla="*/ 2448319 w 2534585"/>
                    <a:gd name="connsiteY15" fmla="*/ 1692030 h 4951352"/>
                    <a:gd name="connsiteX16" fmla="*/ 1766035 w 2534585"/>
                    <a:gd name="connsiteY16" fmla="*/ 2240670 h 4951352"/>
                    <a:gd name="connsiteX17" fmla="*/ 1386208 w 2534585"/>
                    <a:gd name="connsiteY17" fmla="*/ 2810411 h 4951352"/>
                    <a:gd name="connsiteX18" fmla="*/ 1407309 w 2534585"/>
                    <a:gd name="connsiteY18" fmla="*/ 3126934 h 4951352"/>
                    <a:gd name="connsiteX19" fmla="*/ 1864509 w 2534585"/>
                    <a:gd name="connsiteY19" fmla="*/ 3450491 h 4951352"/>
                    <a:gd name="connsiteX20" fmla="*/ 2279506 w 2534585"/>
                    <a:gd name="connsiteY20" fmla="*/ 3682608 h 4951352"/>
                    <a:gd name="connsiteX21" fmla="*/ 2469420 w 2534585"/>
                    <a:gd name="connsiteY21" fmla="*/ 4104639 h 4951352"/>
                    <a:gd name="connsiteX22" fmla="*/ 2237303 w 2534585"/>
                    <a:gd name="connsiteY22" fmla="*/ 4681414 h 4951352"/>
                    <a:gd name="connsiteX23" fmla="*/ 1850442 w 2534585"/>
                    <a:gd name="connsiteY23" fmla="*/ 4941667 h 4951352"/>
                    <a:gd name="connsiteX24" fmla="*/ 900872 w 2534585"/>
                    <a:gd name="connsiteY24" fmla="*/ 4336756 h 495135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2534585" h="4951352">
                      <a:moveTo>
                        <a:pt x="900872" y="4336756"/>
                      </a:moveTo>
                      <a:cubicBezTo>
                        <a:pt x="698063" y="4169116"/>
                        <a:pt x="679306" y="4075332"/>
                        <a:pt x="633586" y="3935827"/>
                      </a:cubicBezTo>
                      <a:cubicBezTo>
                        <a:pt x="587866" y="3796322"/>
                        <a:pt x="648826" y="3647439"/>
                        <a:pt x="626552" y="3499728"/>
                      </a:cubicBezTo>
                      <a:cubicBezTo>
                        <a:pt x="604278" y="3352017"/>
                        <a:pt x="535112" y="3218374"/>
                        <a:pt x="499943" y="3049562"/>
                      </a:cubicBezTo>
                      <a:cubicBezTo>
                        <a:pt x="464774" y="2880750"/>
                        <a:pt x="453051" y="2711937"/>
                        <a:pt x="415537" y="2486854"/>
                      </a:cubicBezTo>
                      <a:cubicBezTo>
                        <a:pt x="378023" y="2261771"/>
                        <a:pt x="329958" y="1903045"/>
                        <a:pt x="274860" y="1699064"/>
                      </a:cubicBezTo>
                      <a:cubicBezTo>
                        <a:pt x="219762" y="1495083"/>
                        <a:pt x="129494" y="1400125"/>
                        <a:pt x="84946" y="1262965"/>
                      </a:cubicBezTo>
                      <a:cubicBezTo>
                        <a:pt x="40398" y="1125805"/>
                        <a:pt x="-21734" y="955821"/>
                        <a:pt x="7574" y="876104"/>
                      </a:cubicBezTo>
                      <a:cubicBezTo>
                        <a:pt x="36882" y="796387"/>
                        <a:pt x="141217" y="823350"/>
                        <a:pt x="260792" y="784664"/>
                      </a:cubicBezTo>
                      <a:cubicBezTo>
                        <a:pt x="380367" y="745978"/>
                        <a:pt x="594900" y="720187"/>
                        <a:pt x="725026" y="643987"/>
                      </a:cubicBezTo>
                      <a:cubicBezTo>
                        <a:pt x="855152" y="567787"/>
                        <a:pt x="963004" y="421249"/>
                        <a:pt x="1041549" y="327464"/>
                      </a:cubicBezTo>
                      <a:cubicBezTo>
                        <a:pt x="1120094" y="233679"/>
                        <a:pt x="1095476" y="128171"/>
                        <a:pt x="1196294" y="81279"/>
                      </a:cubicBezTo>
                      <a:cubicBezTo>
                        <a:pt x="1297112" y="34387"/>
                        <a:pt x="1501094" y="-54708"/>
                        <a:pt x="1646460" y="46110"/>
                      </a:cubicBezTo>
                      <a:cubicBezTo>
                        <a:pt x="1791826" y="146928"/>
                        <a:pt x="1928986" y="491587"/>
                        <a:pt x="2068491" y="686190"/>
                      </a:cubicBezTo>
                      <a:cubicBezTo>
                        <a:pt x="2207996" y="880793"/>
                        <a:pt x="2420183" y="1046088"/>
                        <a:pt x="2483488" y="1213728"/>
                      </a:cubicBezTo>
                      <a:cubicBezTo>
                        <a:pt x="2546793" y="1381368"/>
                        <a:pt x="2567894" y="1520873"/>
                        <a:pt x="2448319" y="1692030"/>
                      </a:cubicBezTo>
                      <a:cubicBezTo>
                        <a:pt x="2328744" y="1863187"/>
                        <a:pt x="1943054" y="2054273"/>
                        <a:pt x="1766035" y="2240670"/>
                      </a:cubicBezTo>
                      <a:cubicBezTo>
                        <a:pt x="1589016" y="2427067"/>
                        <a:pt x="1445996" y="2662700"/>
                        <a:pt x="1386208" y="2810411"/>
                      </a:cubicBezTo>
                      <a:cubicBezTo>
                        <a:pt x="1326420" y="2958122"/>
                        <a:pt x="1327592" y="3020254"/>
                        <a:pt x="1407309" y="3126934"/>
                      </a:cubicBezTo>
                      <a:cubicBezTo>
                        <a:pt x="1487026" y="3233614"/>
                        <a:pt x="1719143" y="3357879"/>
                        <a:pt x="1864509" y="3450491"/>
                      </a:cubicBezTo>
                      <a:cubicBezTo>
                        <a:pt x="2009875" y="3543103"/>
                        <a:pt x="2178688" y="3573583"/>
                        <a:pt x="2279506" y="3682608"/>
                      </a:cubicBezTo>
                      <a:cubicBezTo>
                        <a:pt x="2380324" y="3791633"/>
                        <a:pt x="2476454" y="3938171"/>
                        <a:pt x="2469420" y="4104639"/>
                      </a:cubicBezTo>
                      <a:cubicBezTo>
                        <a:pt x="2462386" y="4271107"/>
                        <a:pt x="2340466" y="4541909"/>
                        <a:pt x="2237303" y="4681414"/>
                      </a:cubicBezTo>
                      <a:cubicBezTo>
                        <a:pt x="2134140" y="4820919"/>
                        <a:pt x="2068491" y="4994421"/>
                        <a:pt x="1850442" y="4941667"/>
                      </a:cubicBezTo>
                      <a:cubicBezTo>
                        <a:pt x="1632393" y="4888913"/>
                        <a:pt x="1103681" y="4504396"/>
                        <a:pt x="900872" y="4336756"/>
                      </a:cubicBezTo>
                      <a:close/>
                    </a:path>
                  </a:pathLst>
                </a:custGeom>
                <a:noFill/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9" name="正方形/長方形 28">
                  <a:extLst>
                    <a:ext uri="{FF2B5EF4-FFF2-40B4-BE49-F238E27FC236}">
                      <a16:creationId xmlns:a16="http://schemas.microsoft.com/office/drawing/2014/main" id="{AA9908EF-0024-D2C2-37AC-96189EA790AC}"/>
                    </a:ext>
                  </a:extLst>
                </p:cNvPr>
                <p:cNvSpPr/>
                <p:nvPr/>
              </p:nvSpPr>
              <p:spPr>
                <a:xfrm>
                  <a:off x="3287652" y="3599580"/>
                  <a:ext cx="186850" cy="8254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1" name="矢印: 右 30">
                  <a:extLst>
                    <a:ext uri="{FF2B5EF4-FFF2-40B4-BE49-F238E27FC236}">
                      <a16:creationId xmlns:a16="http://schemas.microsoft.com/office/drawing/2014/main" id="{15E19B60-BE28-64A4-D75A-94E027ADB23C}"/>
                    </a:ext>
                  </a:extLst>
                </p:cNvPr>
                <p:cNvSpPr/>
                <p:nvPr/>
              </p:nvSpPr>
              <p:spPr>
                <a:xfrm rot="18303591">
                  <a:off x="4870792" y="2965120"/>
                  <a:ext cx="117599" cy="297504"/>
                </a:xfrm>
                <a:prstGeom prst="rightArrow">
                  <a:avLst>
                    <a:gd name="adj1" fmla="val 55728"/>
                    <a:gd name="adj2" fmla="val 50000"/>
                  </a:avLst>
                </a:prstGeom>
                <a:solidFill>
                  <a:srgbClr val="00FF00">
                    <a:alpha val="52549"/>
                  </a:srgb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2" name="矢印: 右 31">
                  <a:extLst>
                    <a:ext uri="{FF2B5EF4-FFF2-40B4-BE49-F238E27FC236}">
                      <a16:creationId xmlns:a16="http://schemas.microsoft.com/office/drawing/2014/main" id="{F96CBDD1-718C-CF76-5BC9-2D0AE6310DA3}"/>
                    </a:ext>
                  </a:extLst>
                </p:cNvPr>
                <p:cNvSpPr/>
                <p:nvPr/>
              </p:nvSpPr>
              <p:spPr>
                <a:xfrm rot="9835912">
                  <a:off x="3988606" y="3285569"/>
                  <a:ext cx="135576" cy="259024"/>
                </a:xfrm>
                <a:prstGeom prst="rightArrow">
                  <a:avLst>
                    <a:gd name="adj1" fmla="val 69603"/>
                    <a:gd name="adj2" fmla="val 50000"/>
                  </a:avLst>
                </a:prstGeom>
                <a:solidFill>
                  <a:srgbClr val="00FF00">
                    <a:alpha val="52549"/>
                  </a:srgb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8" name="フリーフォーム: 図形 47">
                  <a:extLst>
                    <a:ext uri="{FF2B5EF4-FFF2-40B4-BE49-F238E27FC236}">
                      <a16:creationId xmlns:a16="http://schemas.microsoft.com/office/drawing/2014/main" id="{E53D7252-AEF2-B042-99FD-A12F2384E950}"/>
                    </a:ext>
                  </a:extLst>
                </p:cNvPr>
                <p:cNvSpPr/>
                <p:nvPr/>
              </p:nvSpPr>
              <p:spPr>
                <a:xfrm>
                  <a:off x="4325385" y="4549184"/>
                  <a:ext cx="1908233" cy="1846383"/>
                </a:xfrm>
                <a:custGeom>
                  <a:avLst/>
                  <a:gdLst>
                    <a:gd name="connsiteX0" fmla="*/ 666843 w 1908233"/>
                    <a:gd name="connsiteY0" fmla="*/ 21429 h 1846383"/>
                    <a:gd name="connsiteX1" fmla="*/ 601787 w 1908233"/>
                    <a:gd name="connsiteY1" fmla="*/ 10586 h 1846383"/>
                    <a:gd name="connsiteX2" fmla="*/ 457218 w 1908233"/>
                    <a:gd name="connsiteY2" fmla="*/ 10586 h 1846383"/>
                    <a:gd name="connsiteX3" fmla="*/ 269278 w 1908233"/>
                    <a:gd name="connsiteY3" fmla="*/ 147927 h 1846383"/>
                    <a:gd name="connsiteX4" fmla="*/ 139166 w 1908233"/>
                    <a:gd name="connsiteY4" fmla="*/ 484050 h 1846383"/>
                    <a:gd name="connsiteX5" fmla="*/ 16282 w 1908233"/>
                    <a:gd name="connsiteY5" fmla="*/ 1073170 h 1846383"/>
                    <a:gd name="connsiteX6" fmla="*/ 34353 w 1908233"/>
                    <a:gd name="connsiteY6" fmla="*/ 1318937 h 1846383"/>
                    <a:gd name="connsiteX7" fmla="*/ 316263 w 1908233"/>
                    <a:gd name="connsiteY7" fmla="*/ 1539405 h 1846383"/>
                    <a:gd name="connsiteX8" fmla="*/ 984895 w 1908233"/>
                    <a:gd name="connsiteY8" fmla="*/ 1788787 h 1846383"/>
                    <a:gd name="connsiteX9" fmla="*/ 1414989 w 1908233"/>
                    <a:gd name="connsiteY9" fmla="*/ 1828543 h 1846383"/>
                    <a:gd name="connsiteX10" fmla="*/ 1769183 w 1908233"/>
                    <a:gd name="connsiteY10" fmla="*/ 1553862 h 1846383"/>
                    <a:gd name="connsiteX11" fmla="*/ 1902910 w 1908233"/>
                    <a:gd name="connsiteY11" fmla="*/ 1123769 h 1846383"/>
                    <a:gd name="connsiteX12" fmla="*/ 1816168 w 1908233"/>
                    <a:gd name="connsiteY12" fmla="*/ 758732 h 1846383"/>
                    <a:gd name="connsiteX13" fmla="*/ 1248734 w 1908233"/>
                    <a:gd name="connsiteY13" fmla="*/ 386466 h 1846383"/>
                    <a:gd name="connsiteX14" fmla="*/ 974053 w 1908233"/>
                    <a:gd name="connsiteY14" fmla="*/ 147927 h 1846383"/>
                    <a:gd name="connsiteX15" fmla="*/ 872854 w 1908233"/>
                    <a:gd name="connsiteY15" fmla="*/ 35886 h 1846383"/>
                    <a:gd name="connsiteX16" fmla="*/ 666843 w 1908233"/>
                    <a:gd name="connsiteY16" fmla="*/ 21429 h 18463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1908233" h="1846383">
                      <a:moveTo>
                        <a:pt x="666843" y="21429"/>
                      </a:moveTo>
                      <a:cubicBezTo>
                        <a:pt x="621665" y="17212"/>
                        <a:pt x="636724" y="12393"/>
                        <a:pt x="601787" y="10586"/>
                      </a:cubicBezTo>
                      <a:cubicBezTo>
                        <a:pt x="566850" y="8779"/>
                        <a:pt x="512636" y="-12304"/>
                        <a:pt x="457218" y="10586"/>
                      </a:cubicBezTo>
                      <a:cubicBezTo>
                        <a:pt x="401800" y="33476"/>
                        <a:pt x="322287" y="69016"/>
                        <a:pt x="269278" y="147927"/>
                      </a:cubicBezTo>
                      <a:cubicBezTo>
                        <a:pt x="216269" y="226838"/>
                        <a:pt x="181332" y="329843"/>
                        <a:pt x="139166" y="484050"/>
                      </a:cubicBezTo>
                      <a:cubicBezTo>
                        <a:pt x="97000" y="638257"/>
                        <a:pt x="33751" y="934022"/>
                        <a:pt x="16282" y="1073170"/>
                      </a:cubicBezTo>
                      <a:cubicBezTo>
                        <a:pt x="-1187" y="1212318"/>
                        <a:pt x="-15644" y="1241231"/>
                        <a:pt x="34353" y="1318937"/>
                      </a:cubicBezTo>
                      <a:cubicBezTo>
                        <a:pt x="84350" y="1396643"/>
                        <a:pt x="157839" y="1461097"/>
                        <a:pt x="316263" y="1539405"/>
                      </a:cubicBezTo>
                      <a:cubicBezTo>
                        <a:pt x="474687" y="1617713"/>
                        <a:pt x="801774" y="1740597"/>
                        <a:pt x="984895" y="1788787"/>
                      </a:cubicBezTo>
                      <a:cubicBezTo>
                        <a:pt x="1168016" y="1836977"/>
                        <a:pt x="1284274" y="1867697"/>
                        <a:pt x="1414989" y="1828543"/>
                      </a:cubicBezTo>
                      <a:cubicBezTo>
                        <a:pt x="1545704" y="1789389"/>
                        <a:pt x="1687863" y="1671324"/>
                        <a:pt x="1769183" y="1553862"/>
                      </a:cubicBezTo>
                      <a:cubicBezTo>
                        <a:pt x="1850503" y="1436400"/>
                        <a:pt x="1895079" y="1256291"/>
                        <a:pt x="1902910" y="1123769"/>
                      </a:cubicBezTo>
                      <a:cubicBezTo>
                        <a:pt x="1910741" y="991247"/>
                        <a:pt x="1925197" y="881616"/>
                        <a:pt x="1816168" y="758732"/>
                      </a:cubicBezTo>
                      <a:cubicBezTo>
                        <a:pt x="1707139" y="635848"/>
                        <a:pt x="1389087" y="488267"/>
                        <a:pt x="1248734" y="386466"/>
                      </a:cubicBezTo>
                      <a:cubicBezTo>
                        <a:pt x="1108382" y="284665"/>
                        <a:pt x="1036700" y="206357"/>
                        <a:pt x="974053" y="147927"/>
                      </a:cubicBezTo>
                      <a:cubicBezTo>
                        <a:pt x="911406" y="89497"/>
                        <a:pt x="927067" y="59378"/>
                        <a:pt x="872854" y="35886"/>
                      </a:cubicBezTo>
                      <a:cubicBezTo>
                        <a:pt x="818641" y="12394"/>
                        <a:pt x="712021" y="25646"/>
                        <a:pt x="666843" y="21429"/>
                      </a:cubicBezTo>
                      <a:close/>
                    </a:path>
                  </a:pathLst>
                </a:custGeom>
                <a:noFill/>
                <a:ln w="19050">
                  <a:solidFill>
                    <a:srgbClr val="7030A0"/>
                  </a:solidFill>
                  <a:prstDash val="solid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4" name="矢印: 右 33">
                  <a:extLst>
                    <a:ext uri="{FF2B5EF4-FFF2-40B4-BE49-F238E27FC236}">
                      <a16:creationId xmlns:a16="http://schemas.microsoft.com/office/drawing/2014/main" id="{E5203688-A607-5B3B-D607-52D67DF3FFBD}"/>
                    </a:ext>
                  </a:extLst>
                </p:cNvPr>
                <p:cNvSpPr/>
                <p:nvPr/>
              </p:nvSpPr>
              <p:spPr>
                <a:xfrm rot="15938680">
                  <a:off x="4788737" y="4288351"/>
                  <a:ext cx="140512" cy="357557"/>
                </a:xfrm>
                <a:prstGeom prst="rightArrow">
                  <a:avLst/>
                </a:prstGeom>
                <a:solidFill>
                  <a:srgbClr val="00FF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0" name="フリーフォーム: 図形 49">
                  <a:extLst>
                    <a:ext uri="{FF2B5EF4-FFF2-40B4-BE49-F238E27FC236}">
                      <a16:creationId xmlns:a16="http://schemas.microsoft.com/office/drawing/2014/main" id="{16EE94D3-E4BC-5B4E-351D-D7965F02295A}"/>
                    </a:ext>
                  </a:extLst>
                </p:cNvPr>
                <p:cNvSpPr/>
                <p:nvPr/>
              </p:nvSpPr>
              <p:spPr>
                <a:xfrm>
                  <a:off x="1723576" y="2290723"/>
                  <a:ext cx="2267637" cy="1835518"/>
                </a:xfrm>
                <a:custGeom>
                  <a:avLst/>
                  <a:gdLst>
                    <a:gd name="connsiteX0" fmla="*/ 2013537 w 2267637"/>
                    <a:gd name="connsiteY0" fmla="*/ 398264 h 1835518"/>
                    <a:gd name="connsiteX1" fmla="*/ 1941252 w 2267637"/>
                    <a:gd name="connsiteY1" fmla="*/ 268151 h 1835518"/>
                    <a:gd name="connsiteX2" fmla="*/ 1706328 w 2267637"/>
                    <a:gd name="connsiteY2" fmla="*/ 80211 h 1835518"/>
                    <a:gd name="connsiteX3" fmla="*/ 1182264 w 2267637"/>
                    <a:gd name="connsiteY3" fmla="*/ 698 h 1835518"/>
                    <a:gd name="connsiteX4" fmla="*/ 564231 w 2267637"/>
                    <a:gd name="connsiteY4" fmla="*/ 119968 h 1835518"/>
                    <a:gd name="connsiteX5" fmla="*/ 202808 w 2267637"/>
                    <a:gd name="connsiteY5" fmla="*/ 300679 h 1835518"/>
                    <a:gd name="connsiteX6" fmla="*/ 14868 w 2267637"/>
                    <a:gd name="connsiteY6" fmla="*/ 1034368 h 1835518"/>
                    <a:gd name="connsiteX7" fmla="*/ 40168 w 2267637"/>
                    <a:gd name="connsiteY7" fmla="*/ 1536746 h 1835518"/>
                    <a:gd name="connsiteX8" fmla="*/ 264250 w 2267637"/>
                    <a:gd name="connsiteY8" fmla="*/ 1666858 h 1835518"/>
                    <a:gd name="connsiteX9" fmla="*/ 502789 w 2267637"/>
                    <a:gd name="connsiteY9" fmla="*/ 1609030 h 1835518"/>
                    <a:gd name="connsiteX10" fmla="*/ 824456 w 2267637"/>
                    <a:gd name="connsiteY10" fmla="*/ 1670472 h 1835518"/>
                    <a:gd name="connsiteX11" fmla="*/ 1388275 w 2267637"/>
                    <a:gd name="connsiteY11" fmla="*/ 1789742 h 1835518"/>
                    <a:gd name="connsiteX12" fmla="*/ 1648500 w 2267637"/>
                    <a:gd name="connsiteY12" fmla="*/ 1811427 h 1835518"/>
                    <a:gd name="connsiteX13" fmla="*/ 1923181 w 2267637"/>
                    <a:gd name="connsiteY13" fmla="*/ 1829498 h 1835518"/>
                    <a:gd name="connsiteX14" fmla="*/ 2074979 w 2267637"/>
                    <a:gd name="connsiteY14" fmla="*/ 1699386 h 1835518"/>
                    <a:gd name="connsiteX15" fmla="*/ 2226777 w 2267637"/>
                    <a:gd name="connsiteY15" fmla="*/ 1337963 h 1835518"/>
                    <a:gd name="connsiteX16" fmla="*/ 2252076 w 2267637"/>
                    <a:gd name="connsiteY16" fmla="*/ 1099424 h 1835518"/>
                    <a:gd name="connsiteX17" fmla="*/ 2013537 w 2267637"/>
                    <a:gd name="connsiteY17" fmla="*/ 398264 h 18355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</a:cxnLst>
                  <a:rect l="l" t="t" r="r" b="b"/>
                  <a:pathLst>
                    <a:path w="2267637" h="1835518">
                      <a:moveTo>
                        <a:pt x="2013537" y="398264"/>
                      </a:moveTo>
                      <a:cubicBezTo>
                        <a:pt x="1961733" y="259718"/>
                        <a:pt x="1992453" y="321160"/>
                        <a:pt x="1941252" y="268151"/>
                      </a:cubicBezTo>
                      <a:cubicBezTo>
                        <a:pt x="1890051" y="215142"/>
                        <a:pt x="1832826" y="124786"/>
                        <a:pt x="1706328" y="80211"/>
                      </a:cubicBezTo>
                      <a:cubicBezTo>
                        <a:pt x="1579830" y="35635"/>
                        <a:pt x="1372613" y="-5928"/>
                        <a:pt x="1182264" y="698"/>
                      </a:cubicBezTo>
                      <a:cubicBezTo>
                        <a:pt x="991915" y="7324"/>
                        <a:pt x="727474" y="69971"/>
                        <a:pt x="564231" y="119968"/>
                      </a:cubicBezTo>
                      <a:cubicBezTo>
                        <a:pt x="400988" y="169965"/>
                        <a:pt x="294368" y="148279"/>
                        <a:pt x="202808" y="300679"/>
                      </a:cubicBezTo>
                      <a:cubicBezTo>
                        <a:pt x="111247" y="453079"/>
                        <a:pt x="41975" y="828357"/>
                        <a:pt x="14868" y="1034368"/>
                      </a:cubicBezTo>
                      <a:cubicBezTo>
                        <a:pt x="-12239" y="1240379"/>
                        <a:pt x="-1396" y="1431331"/>
                        <a:pt x="40168" y="1536746"/>
                      </a:cubicBezTo>
                      <a:cubicBezTo>
                        <a:pt x="81732" y="1642161"/>
                        <a:pt x="187147" y="1654811"/>
                        <a:pt x="264250" y="1666858"/>
                      </a:cubicBezTo>
                      <a:cubicBezTo>
                        <a:pt x="341353" y="1678905"/>
                        <a:pt x="409421" y="1608428"/>
                        <a:pt x="502789" y="1609030"/>
                      </a:cubicBezTo>
                      <a:cubicBezTo>
                        <a:pt x="596157" y="1609632"/>
                        <a:pt x="824456" y="1670472"/>
                        <a:pt x="824456" y="1670472"/>
                      </a:cubicBezTo>
                      <a:cubicBezTo>
                        <a:pt x="972037" y="1700591"/>
                        <a:pt x="1250935" y="1766250"/>
                        <a:pt x="1388275" y="1789742"/>
                      </a:cubicBezTo>
                      <a:cubicBezTo>
                        <a:pt x="1525615" y="1813234"/>
                        <a:pt x="1648500" y="1811427"/>
                        <a:pt x="1648500" y="1811427"/>
                      </a:cubicBezTo>
                      <a:cubicBezTo>
                        <a:pt x="1737651" y="1818053"/>
                        <a:pt x="1852101" y="1848171"/>
                        <a:pt x="1923181" y="1829498"/>
                      </a:cubicBezTo>
                      <a:cubicBezTo>
                        <a:pt x="1994261" y="1810825"/>
                        <a:pt x="2024380" y="1781309"/>
                        <a:pt x="2074979" y="1699386"/>
                      </a:cubicBezTo>
                      <a:cubicBezTo>
                        <a:pt x="2125578" y="1617463"/>
                        <a:pt x="2197261" y="1437957"/>
                        <a:pt x="2226777" y="1337963"/>
                      </a:cubicBezTo>
                      <a:cubicBezTo>
                        <a:pt x="2256293" y="1237969"/>
                        <a:pt x="2287014" y="1253631"/>
                        <a:pt x="2252076" y="1099424"/>
                      </a:cubicBezTo>
                      <a:cubicBezTo>
                        <a:pt x="2217138" y="945217"/>
                        <a:pt x="2065341" y="536810"/>
                        <a:pt x="2013537" y="398264"/>
                      </a:cubicBezTo>
                      <a:close/>
                    </a:path>
                  </a:pathLst>
                </a:custGeom>
                <a:noFill/>
                <a:ln w="19050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1" name="正方形/長方形 50">
                  <a:extLst>
                    <a:ext uri="{FF2B5EF4-FFF2-40B4-BE49-F238E27FC236}">
                      <a16:creationId xmlns:a16="http://schemas.microsoft.com/office/drawing/2014/main" id="{913FC3FE-E348-0422-94E9-53905F0829BE}"/>
                    </a:ext>
                  </a:extLst>
                </p:cNvPr>
                <p:cNvSpPr/>
                <p:nvPr/>
              </p:nvSpPr>
              <p:spPr>
                <a:xfrm>
                  <a:off x="2570290" y="3118138"/>
                  <a:ext cx="186850" cy="8254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3" name="正方形/長方形 52">
                  <a:extLst>
                    <a:ext uri="{FF2B5EF4-FFF2-40B4-BE49-F238E27FC236}">
                      <a16:creationId xmlns:a16="http://schemas.microsoft.com/office/drawing/2014/main" id="{F6382B0B-7AC7-E422-C414-62CBF4AD6D85}"/>
                    </a:ext>
                  </a:extLst>
                </p:cNvPr>
                <p:cNvSpPr/>
                <p:nvPr/>
              </p:nvSpPr>
              <p:spPr>
                <a:xfrm>
                  <a:off x="6764442" y="4271683"/>
                  <a:ext cx="221799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4" name="正方形/長方形 53">
                  <a:extLst>
                    <a:ext uri="{FF2B5EF4-FFF2-40B4-BE49-F238E27FC236}">
                      <a16:creationId xmlns:a16="http://schemas.microsoft.com/office/drawing/2014/main" id="{3B12A604-00F4-AAEB-66BA-39E1A6BDBC98}"/>
                    </a:ext>
                  </a:extLst>
                </p:cNvPr>
                <p:cNvSpPr/>
                <p:nvPr/>
              </p:nvSpPr>
              <p:spPr>
                <a:xfrm>
                  <a:off x="5415783" y="4808935"/>
                  <a:ext cx="254255" cy="105508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7" name="正方形/長方形 56">
                  <a:extLst>
                    <a:ext uri="{FF2B5EF4-FFF2-40B4-BE49-F238E27FC236}">
                      <a16:creationId xmlns:a16="http://schemas.microsoft.com/office/drawing/2014/main" id="{FC24D359-2F23-348A-8024-3BDAB94A4C5B}"/>
                    </a:ext>
                  </a:extLst>
                </p:cNvPr>
                <p:cNvSpPr/>
                <p:nvPr/>
              </p:nvSpPr>
              <p:spPr>
                <a:xfrm>
                  <a:off x="6778268" y="4549872"/>
                  <a:ext cx="221799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8" name="正方形/長方形 57">
                  <a:extLst>
                    <a:ext uri="{FF2B5EF4-FFF2-40B4-BE49-F238E27FC236}">
                      <a16:creationId xmlns:a16="http://schemas.microsoft.com/office/drawing/2014/main" id="{73482F7E-14CC-47E5-1336-D58B89579F33}"/>
                    </a:ext>
                  </a:extLst>
                </p:cNvPr>
                <p:cNvSpPr/>
                <p:nvPr/>
              </p:nvSpPr>
              <p:spPr>
                <a:xfrm>
                  <a:off x="6352452" y="4470969"/>
                  <a:ext cx="221799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9" name="正方形/長方形 58">
                  <a:extLst>
                    <a:ext uri="{FF2B5EF4-FFF2-40B4-BE49-F238E27FC236}">
                      <a16:creationId xmlns:a16="http://schemas.microsoft.com/office/drawing/2014/main" id="{5EA2190D-3313-09A8-1C2C-7CFB31763F31}"/>
                    </a:ext>
                  </a:extLst>
                </p:cNvPr>
                <p:cNvSpPr/>
                <p:nvPr/>
              </p:nvSpPr>
              <p:spPr>
                <a:xfrm>
                  <a:off x="3391039" y="5023176"/>
                  <a:ext cx="180046" cy="8843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0" name="正方形/長方形 59">
                  <a:extLst>
                    <a:ext uri="{FF2B5EF4-FFF2-40B4-BE49-F238E27FC236}">
                      <a16:creationId xmlns:a16="http://schemas.microsoft.com/office/drawing/2014/main" id="{3FE7D38A-46F1-9249-326F-001F7E1DD7CF}"/>
                    </a:ext>
                  </a:extLst>
                </p:cNvPr>
                <p:cNvSpPr/>
                <p:nvPr/>
              </p:nvSpPr>
              <p:spPr>
                <a:xfrm>
                  <a:off x="3132726" y="5573259"/>
                  <a:ext cx="180046" cy="8843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1" name="正方形/長方形 60">
                  <a:extLst>
                    <a:ext uri="{FF2B5EF4-FFF2-40B4-BE49-F238E27FC236}">
                      <a16:creationId xmlns:a16="http://schemas.microsoft.com/office/drawing/2014/main" id="{4BBEFE9C-8B23-6594-2D21-6B044B1BDDBE}"/>
                    </a:ext>
                  </a:extLst>
                </p:cNvPr>
                <p:cNvSpPr/>
                <p:nvPr/>
              </p:nvSpPr>
              <p:spPr>
                <a:xfrm>
                  <a:off x="3010409" y="5163386"/>
                  <a:ext cx="180046" cy="8843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2" name="正方形/長方形 61">
                  <a:extLst>
                    <a:ext uri="{FF2B5EF4-FFF2-40B4-BE49-F238E27FC236}">
                      <a16:creationId xmlns:a16="http://schemas.microsoft.com/office/drawing/2014/main" id="{C10CA88F-277D-BEB6-21C7-35426F94AFA0}"/>
                    </a:ext>
                  </a:extLst>
                </p:cNvPr>
                <p:cNvSpPr/>
                <p:nvPr/>
              </p:nvSpPr>
              <p:spPr>
                <a:xfrm>
                  <a:off x="3042703" y="4910848"/>
                  <a:ext cx="180046" cy="8843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3" name="正方形/長方形 62">
                  <a:extLst>
                    <a:ext uri="{FF2B5EF4-FFF2-40B4-BE49-F238E27FC236}">
                      <a16:creationId xmlns:a16="http://schemas.microsoft.com/office/drawing/2014/main" id="{70A385C1-2C07-110E-D6CE-CC826CE91458}"/>
                    </a:ext>
                  </a:extLst>
                </p:cNvPr>
                <p:cNvSpPr/>
                <p:nvPr/>
              </p:nvSpPr>
              <p:spPr>
                <a:xfrm>
                  <a:off x="2768876" y="5692730"/>
                  <a:ext cx="180046" cy="8843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4" name="正方形/長方形 63">
                  <a:extLst>
                    <a:ext uri="{FF2B5EF4-FFF2-40B4-BE49-F238E27FC236}">
                      <a16:creationId xmlns:a16="http://schemas.microsoft.com/office/drawing/2014/main" id="{1C32540D-E4B3-8390-9983-268A7259776C}"/>
                    </a:ext>
                  </a:extLst>
                </p:cNvPr>
                <p:cNvSpPr/>
                <p:nvPr/>
              </p:nvSpPr>
              <p:spPr>
                <a:xfrm>
                  <a:off x="2462470" y="1717554"/>
                  <a:ext cx="294669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5" name="正方形/長方形 64">
                  <a:extLst>
                    <a:ext uri="{FF2B5EF4-FFF2-40B4-BE49-F238E27FC236}">
                      <a16:creationId xmlns:a16="http://schemas.microsoft.com/office/drawing/2014/main" id="{65875F3C-36E1-CC8B-69F0-D3F8F703BBA5}"/>
                    </a:ext>
                  </a:extLst>
                </p:cNvPr>
                <p:cNvSpPr/>
                <p:nvPr/>
              </p:nvSpPr>
              <p:spPr>
                <a:xfrm>
                  <a:off x="2787942" y="1317569"/>
                  <a:ext cx="294669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6" name="正方形/長方形 65">
                  <a:extLst>
                    <a:ext uri="{FF2B5EF4-FFF2-40B4-BE49-F238E27FC236}">
                      <a16:creationId xmlns:a16="http://schemas.microsoft.com/office/drawing/2014/main" id="{D845FC26-17F9-46E0-62A4-4E2A4EE807DA}"/>
                    </a:ext>
                  </a:extLst>
                </p:cNvPr>
                <p:cNvSpPr/>
                <p:nvPr/>
              </p:nvSpPr>
              <p:spPr>
                <a:xfrm>
                  <a:off x="2687310" y="1473497"/>
                  <a:ext cx="294669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7" name="正方形/長方形 66">
                  <a:extLst>
                    <a:ext uri="{FF2B5EF4-FFF2-40B4-BE49-F238E27FC236}">
                      <a16:creationId xmlns:a16="http://schemas.microsoft.com/office/drawing/2014/main" id="{A59E7471-9A4F-A486-36F3-D5DAA707B2C8}"/>
                    </a:ext>
                  </a:extLst>
                </p:cNvPr>
                <p:cNvSpPr/>
                <p:nvPr/>
              </p:nvSpPr>
              <p:spPr>
                <a:xfrm>
                  <a:off x="2423955" y="1502676"/>
                  <a:ext cx="246549" cy="12012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8" name="正方形/長方形 67">
                  <a:extLst>
                    <a:ext uri="{FF2B5EF4-FFF2-40B4-BE49-F238E27FC236}">
                      <a16:creationId xmlns:a16="http://schemas.microsoft.com/office/drawing/2014/main" id="{7684584F-8D07-37C9-E627-89B963EECDDE}"/>
                    </a:ext>
                  </a:extLst>
                </p:cNvPr>
                <p:cNvSpPr/>
                <p:nvPr/>
              </p:nvSpPr>
              <p:spPr>
                <a:xfrm>
                  <a:off x="2587279" y="1268350"/>
                  <a:ext cx="246549" cy="12012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9" name="正方形/長方形 68">
                  <a:extLst>
                    <a:ext uri="{FF2B5EF4-FFF2-40B4-BE49-F238E27FC236}">
                      <a16:creationId xmlns:a16="http://schemas.microsoft.com/office/drawing/2014/main" id="{92938168-D15B-A876-4A3E-81CFFCE06C53}"/>
                    </a:ext>
                  </a:extLst>
                </p:cNvPr>
                <p:cNvSpPr/>
                <p:nvPr/>
              </p:nvSpPr>
              <p:spPr>
                <a:xfrm>
                  <a:off x="2142936" y="580809"/>
                  <a:ext cx="246549" cy="12012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0" name="正方形/長方形 69">
                  <a:extLst>
                    <a:ext uri="{FF2B5EF4-FFF2-40B4-BE49-F238E27FC236}">
                      <a16:creationId xmlns:a16="http://schemas.microsoft.com/office/drawing/2014/main" id="{0351D661-65DB-ABC2-B1CC-FE6781B4ED6C}"/>
                    </a:ext>
                  </a:extLst>
                </p:cNvPr>
                <p:cNvSpPr/>
                <p:nvPr/>
              </p:nvSpPr>
              <p:spPr>
                <a:xfrm>
                  <a:off x="2214516" y="887908"/>
                  <a:ext cx="246549" cy="12012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1" name="正方形/長方形 70">
                  <a:extLst>
                    <a:ext uri="{FF2B5EF4-FFF2-40B4-BE49-F238E27FC236}">
                      <a16:creationId xmlns:a16="http://schemas.microsoft.com/office/drawing/2014/main" id="{EE2F5679-1092-89F2-9F9D-1A1CFAEF60A4}"/>
                    </a:ext>
                  </a:extLst>
                </p:cNvPr>
                <p:cNvSpPr/>
                <p:nvPr/>
              </p:nvSpPr>
              <p:spPr>
                <a:xfrm>
                  <a:off x="1869899" y="843705"/>
                  <a:ext cx="213097" cy="11303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2" name="正方形/長方形 71">
                  <a:extLst>
                    <a:ext uri="{FF2B5EF4-FFF2-40B4-BE49-F238E27FC236}">
                      <a16:creationId xmlns:a16="http://schemas.microsoft.com/office/drawing/2014/main" id="{04FB08EB-9666-F615-6B2B-122107E4BD91}"/>
                    </a:ext>
                  </a:extLst>
                </p:cNvPr>
                <p:cNvSpPr/>
                <p:nvPr/>
              </p:nvSpPr>
              <p:spPr>
                <a:xfrm>
                  <a:off x="1957768" y="670532"/>
                  <a:ext cx="186845" cy="12012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3" name="正方形/長方形 72">
                  <a:extLst>
                    <a:ext uri="{FF2B5EF4-FFF2-40B4-BE49-F238E27FC236}">
                      <a16:creationId xmlns:a16="http://schemas.microsoft.com/office/drawing/2014/main" id="{A13E98FA-50F8-F722-E8D7-73C325AF279E}"/>
                    </a:ext>
                  </a:extLst>
                </p:cNvPr>
                <p:cNvSpPr/>
                <p:nvPr/>
              </p:nvSpPr>
              <p:spPr>
                <a:xfrm>
                  <a:off x="4112439" y="1073526"/>
                  <a:ext cx="245454" cy="1130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4" name="正方形/長方形 73">
                  <a:extLst>
                    <a:ext uri="{FF2B5EF4-FFF2-40B4-BE49-F238E27FC236}">
                      <a16:creationId xmlns:a16="http://schemas.microsoft.com/office/drawing/2014/main" id="{F9794F12-8287-189E-5CA2-44171332AEDD}"/>
                    </a:ext>
                  </a:extLst>
                </p:cNvPr>
                <p:cNvSpPr/>
                <p:nvPr/>
              </p:nvSpPr>
              <p:spPr>
                <a:xfrm>
                  <a:off x="4130345" y="1653449"/>
                  <a:ext cx="177069" cy="9880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5" name="正方形/長方形 74">
                  <a:extLst>
                    <a:ext uri="{FF2B5EF4-FFF2-40B4-BE49-F238E27FC236}">
                      <a16:creationId xmlns:a16="http://schemas.microsoft.com/office/drawing/2014/main" id="{E7AAC089-0BBF-7AA8-4056-64F876F32C13}"/>
                    </a:ext>
                  </a:extLst>
                </p:cNvPr>
                <p:cNvSpPr/>
                <p:nvPr/>
              </p:nvSpPr>
              <p:spPr>
                <a:xfrm>
                  <a:off x="4098994" y="1841029"/>
                  <a:ext cx="178277" cy="9820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6" name="正方形/長方形 75">
                  <a:extLst>
                    <a:ext uri="{FF2B5EF4-FFF2-40B4-BE49-F238E27FC236}">
                      <a16:creationId xmlns:a16="http://schemas.microsoft.com/office/drawing/2014/main" id="{2716473D-70C3-7141-428B-52B4049A4CBA}"/>
                    </a:ext>
                  </a:extLst>
                </p:cNvPr>
                <p:cNvSpPr/>
                <p:nvPr/>
              </p:nvSpPr>
              <p:spPr>
                <a:xfrm>
                  <a:off x="3765804" y="848051"/>
                  <a:ext cx="174126" cy="13027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7" name="正方形/長方形 76">
                  <a:extLst>
                    <a:ext uri="{FF2B5EF4-FFF2-40B4-BE49-F238E27FC236}">
                      <a16:creationId xmlns:a16="http://schemas.microsoft.com/office/drawing/2014/main" id="{8FDF38D7-BBC6-23B5-E577-F0850F5118C7}"/>
                    </a:ext>
                  </a:extLst>
                </p:cNvPr>
                <p:cNvSpPr/>
                <p:nvPr/>
              </p:nvSpPr>
              <p:spPr>
                <a:xfrm>
                  <a:off x="4233691" y="2102611"/>
                  <a:ext cx="178277" cy="9820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8" name="正方形/長方形 77">
                  <a:extLst>
                    <a:ext uri="{FF2B5EF4-FFF2-40B4-BE49-F238E27FC236}">
                      <a16:creationId xmlns:a16="http://schemas.microsoft.com/office/drawing/2014/main" id="{3DC0D3CA-7C2A-B052-2ADD-C3E5E2BEBC8F}"/>
                    </a:ext>
                  </a:extLst>
                </p:cNvPr>
                <p:cNvSpPr/>
                <p:nvPr/>
              </p:nvSpPr>
              <p:spPr>
                <a:xfrm>
                  <a:off x="4176204" y="2018967"/>
                  <a:ext cx="178277" cy="9820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79" name="正方形/長方形 78">
                  <a:extLst>
                    <a:ext uri="{FF2B5EF4-FFF2-40B4-BE49-F238E27FC236}">
                      <a16:creationId xmlns:a16="http://schemas.microsoft.com/office/drawing/2014/main" id="{D0725746-6F26-201C-8A24-EECF6F0AD5AE}"/>
                    </a:ext>
                  </a:extLst>
                </p:cNvPr>
                <p:cNvSpPr/>
                <p:nvPr/>
              </p:nvSpPr>
              <p:spPr>
                <a:xfrm>
                  <a:off x="4386091" y="2255011"/>
                  <a:ext cx="178277" cy="9820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0" name="正方形/長方形 79">
                  <a:extLst>
                    <a:ext uri="{FF2B5EF4-FFF2-40B4-BE49-F238E27FC236}">
                      <a16:creationId xmlns:a16="http://schemas.microsoft.com/office/drawing/2014/main" id="{86A84F97-8B5B-2853-94CF-1C2AADBA435D}"/>
                    </a:ext>
                  </a:extLst>
                </p:cNvPr>
                <p:cNvSpPr/>
                <p:nvPr/>
              </p:nvSpPr>
              <p:spPr>
                <a:xfrm>
                  <a:off x="4490422" y="1046166"/>
                  <a:ext cx="198322" cy="10774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1" name="正方形/長方形 80">
                  <a:extLst>
                    <a:ext uri="{FF2B5EF4-FFF2-40B4-BE49-F238E27FC236}">
                      <a16:creationId xmlns:a16="http://schemas.microsoft.com/office/drawing/2014/main" id="{0BF3B784-0D04-6380-0948-E0FB9A55EDB5}"/>
                    </a:ext>
                  </a:extLst>
                </p:cNvPr>
                <p:cNvSpPr/>
                <p:nvPr/>
              </p:nvSpPr>
              <p:spPr>
                <a:xfrm>
                  <a:off x="5724420" y="330558"/>
                  <a:ext cx="198322" cy="10774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2" name="正方形/長方形 81">
                  <a:extLst>
                    <a:ext uri="{FF2B5EF4-FFF2-40B4-BE49-F238E27FC236}">
                      <a16:creationId xmlns:a16="http://schemas.microsoft.com/office/drawing/2014/main" id="{04E73512-9A86-D49B-BB4E-D3CFB5BE51A1}"/>
                    </a:ext>
                  </a:extLst>
                </p:cNvPr>
                <p:cNvSpPr/>
                <p:nvPr/>
              </p:nvSpPr>
              <p:spPr>
                <a:xfrm>
                  <a:off x="5692513" y="599606"/>
                  <a:ext cx="198322" cy="10774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3" name="正方形/長方形 82">
                  <a:extLst>
                    <a:ext uri="{FF2B5EF4-FFF2-40B4-BE49-F238E27FC236}">
                      <a16:creationId xmlns:a16="http://schemas.microsoft.com/office/drawing/2014/main" id="{FDFDA1EB-6C8B-744B-DCB2-CEAFA658019D}"/>
                    </a:ext>
                  </a:extLst>
                </p:cNvPr>
                <p:cNvSpPr/>
                <p:nvPr/>
              </p:nvSpPr>
              <p:spPr>
                <a:xfrm>
                  <a:off x="6663251" y="1353723"/>
                  <a:ext cx="266239" cy="11977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4" name="正方形/長方形 83">
                  <a:extLst>
                    <a:ext uri="{FF2B5EF4-FFF2-40B4-BE49-F238E27FC236}">
                      <a16:creationId xmlns:a16="http://schemas.microsoft.com/office/drawing/2014/main" id="{BCB23519-B4E1-2337-5682-F49F19304694}"/>
                    </a:ext>
                  </a:extLst>
                </p:cNvPr>
                <p:cNvSpPr/>
                <p:nvPr/>
              </p:nvSpPr>
              <p:spPr>
                <a:xfrm>
                  <a:off x="7243138" y="1258072"/>
                  <a:ext cx="266239" cy="13040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5" name="正方形/長方形 84">
                  <a:extLst>
                    <a:ext uri="{FF2B5EF4-FFF2-40B4-BE49-F238E27FC236}">
                      <a16:creationId xmlns:a16="http://schemas.microsoft.com/office/drawing/2014/main" id="{9B15A2F8-02A3-5139-9BCC-4AACD70D099D}"/>
                    </a:ext>
                  </a:extLst>
                </p:cNvPr>
                <p:cNvSpPr/>
                <p:nvPr/>
              </p:nvSpPr>
              <p:spPr>
                <a:xfrm>
                  <a:off x="6064735" y="1675613"/>
                  <a:ext cx="198322" cy="10774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6" name="正方形/長方形 85">
                  <a:extLst>
                    <a:ext uri="{FF2B5EF4-FFF2-40B4-BE49-F238E27FC236}">
                      <a16:creationId xmlns:a16="http://schemas.microsoft.com/office/drawing/2014/main" id="{BF0EFC83-DA6D-A115-75C8-4A6AC643F988}"/>
                    </a:ext>
                  </a:extLst>
                </p:cNvPr>
                <p:cNvSpPr/>
                <p:nvPr/>
              </p:nvSpPr>
              <p:spPr>
                <a:xfrm>
                  <a:off x="6773352" y="1881836"/>
                  <a:ext cx="246031" cy="11977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7" name="正方形/長方形 86">
                  <a:extLst>
                    <a:ext uri="{FF2B5EF4-FFF2-40B4-BE49-F238E27FC236}">
                      <a16:creationId xmlns:a16="http://schemas.microsoft.com/office/drawing/2014/main" id="{902BE199-40E3-B5A8-0214-EEED707C612A}"/>
                    </a:ext>
                  </a:extLst>
                </p:cNvPr>
                <p:cNvSpPr/>
                <p:nvPr/>
              </p:nvSpPr>
              <p:spPr>
                <a:xfrm>
                  <a:off x="6640641" y="1765945"/>
                  <a:ext cx="193922" cy="11977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8" name="正方形/長方形 87">
                  <a:extLst>
                    <a:ext uri="{FF2B5EF4-FFF2-40B4-BE49-F238E27FC236}">
                      <a16:creationId xmlns:a16="http://schemas.microsoft.com/office/drawing/2014/main" id="{C81A80BD-4144-C8FC-3C8E-7225638A1DC6}"/>
                    </a:ext>
                  </a:extLst>
                </p:cNvPr>
                <p:cNvSpPr/>
                <p:nvPr/>
              </p:nvSpPr>
              <p:spPr>
                <a:xfrm>
                  <a:off x="6417220" y="1879092"/>
                  <a:ext cx="246031" cy="11977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9" name="正方形/長方形 88">
                  <a:extLst>
                    <a:ext uri="{FF2B5EF4-FFF2-40B4-BE49-F238E27FC236}">
                      <a16:creationId xmlns:a16="http://schemas.microsoft.com/office/drawing/2014/main" id="{1CA1FD29-A833-B9E5-EC2B-A5024CE33A51}"/>
                    </a:ext>
                  </a:extLst>
                </p:cNvPr>
                <p:cNvSpPr/>
                <p:nvPr/>
              </p:nvSpPr>
              <p:spPr>
                <a:xfrm>
                  <a:off x="6570558" y="2091825"/>
                  <a:ext cx="246031" cy="11977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0" name="正方形/長方形 89">
                  <a:extLst>
                    <a:ext uri="{FF2B5EF4-FFF2-40B4-BE49-F238E27FC236}">
                      <a16:creationId xmlns:a16="http://schemas.microsoft.com/office/drawing/2014/main" id="{0CDF655A-D84D-EB73-4664-F59B14B70177}"/>
                    </a:ext>
                  </a:extLst>
                </p:cNvPr>
                <p:cNvSpPr/>
                <p:nvPr/>
              </p:nvSpPr>
              <p:spPr>
                <a:xfrm>
                  <a:off x="6877953" y="5132862"/>
                  <a:ext cx="221799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1" name="正方形/長方形 90">
                  <a:extLst>
                    <a:ext uri="{FF2B5EF4-FFF2-40B4-BE49-F238E27FC236}">
                      <a16:creationId xmlns:a16="http://schemas.microsoft.com/office/drawing/2014/main" id="{2F649FB4-1862-9643-ACAE-D47F55329A26}"/>
                    </a:ext>
                  </a:extLst>
                </p:cNvPr>
                <p:cNvSpPr/>
                <p:nvPr/>
              </p:nvSpPr>
              <p:spPr>
                <a:xfrm>
                  <a:off x="7704437" y="5421070"/>
                  <a:ext cx="232131" cy="9710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2" name="正方形/長方形 91">
                  <a:extLst>
                    <a:ext uri="{FF2B5EF4-FFF2-40B4-BE49-F238E27FC236}">
                      <a16:creationId xmlns:a16="http://schemas.microsoft.com/office/drawing/2014/main" id="{24515D5B-BDBA-CB4E-54F9-B1E5E04396FD}"/>
                    </a:ext>
                  </a:extLst>
                </p:cNvPr>
                <p:cNvSpPr/>
                <p:nvPr/>
              </p:nvSpPr>
              <p:spPr>
                <a:xfrm>
                  <a:off x="7416999" y="5453897"/>
                  <a:ext cx="261843" cy="9710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3" name="正方形/長方形 92">
                  <a:extLst>
                    <a:ext uri="{FF2B5EF4-FFF2-40B4-BE49-F238E27FC236}">
                      <a16:creationId xmlns:a16="http://schemas.microsoft.com/office/drawing/2014/main" id="{D7DE514C-5CC0-99CE-0F0B-CA23222B4793}"/>
                    </a:ext>
                  </a:extLst>
                </p:cNvPr>
                <p:cNvSpPr/>
                <p:nvPr/>
              </p:nvSpPr>
              <p:spPr>
                <a:xfrm>
                  <a:off x="6809527" y="5335053"/>
                  <a:ext cx="221799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4" name="正方形/長方形 93">
                  <a:extLst>
                    <a:ext uri="{FF2B5EF4-FFF2-40B4-BE49-F238E27FC236}">
                      <a16:creationId xmlns:a16="http://schemas.microsoft.com/office/drawing/2014/main" id="{20D0203F-E042-3A24-36F0-31B121C73703}"/>
                    </a:ext>
                  </a:extLst>
                </p:cNvPr>
                <p:cNvSpPr/>
                <p:nvPr/>
              </p:nvSpPr>
              <p:spPr>
                <a:xfrm>
                  <a:off x="6832839" y="5639853"/>
                  <a:ext cx="198487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5" name="正方形/長方形 94">
                  <a:extLst>
                    <a:ext uri="{FF2B5EF4-FFF2-40B4-BE49-F238E27FC236}">
                      <a16:creationId xmlns:a16="http://schemas.microsoft.com/office/drawing/2014/main" id="{EFCD49B0-6E58-EB11-C992-E049609FE7AC}"/>
                    </a:ext>
                  </a:extLst>
                </p:cNvPr>
                <p:cNvSpPr/>
                <p:nvPr/>
              </p:nvSpPr>
              <p:spPr>
                <a:xfrm>
                  <a:off x="6386016" y="5618869"/>
                  <a:ext cx="198487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6" name="正方形/長方形 95">
                  <a:extLst>
                    <a:ext uri="{FF2B5EF4-FFF2-40B4-BE49-F238E27FC236}">
                      <a16:creationId xmlns:a16="http://schemas.microsoft.com/office/drawing/2014/main" id="{372580A9-F6CF-5628-5AF9-AACA656C2F93}"/>
                    </a:ext>
                  </a:extLst>
                </p:cNvPr>
                <p:cNvSpPr/>
                <p:nvPr/>
              </p:nvSpPr>
              <p:spPr>
                <a:xfrm>
                  <a:off x="6279874" y="5817555"/>
                  <a:ext cx="198487" cy="102609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solidFill>
                      <a:schemeClr val="tx1"/>
                    </a:solidFill>
                  </a:endParaRPr>
                </a:p>
              </p:txBody>
            </p:sp>
          </p:grpSp>
        </p:grp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F9A28E8A-4416-3453-1D91-43529219B70E}"/>
                </a:ext>
              </a:extLst>
            </p:cNvPr>
            <p:cNvSpPr txBox="1"/>
            <p:nvPr/>
          </p:nvSpPr>
          <p:spPr>
            <a:xfrm>
              <a:off x="3770964" y="6316126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M-1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フリーフォーム: 図形 45">
              <a:extLst>
                <a:ext uri="{FF2B5EF4-FFF2-40B4-BE49-F238E27FC236}">
                  <a16:creationId xmlns:a16="http://schemas.microsoft.com/office/drawing/2014/main" id="{0DBF2B85-35FA-2BA2-08AB-A3A68AD55603}"/>
                </a:ext>
              </a:extLst>
            </p:cNvPr>
            <p:cNvSpPr/>
            <p:nvPr/>
          </p:nvSpPr>
          <p:spPr>
            <a:xfrm rot="1090946">
              <a:off x="4171059" y="6068243"/>
              <a:ext cx="79674" cy="264382"/>
            </a:xfrm>
            <a:custGeom>
              <a:avLst/>
              <a:gdLst>
                <a:gd name="connsiteX0" fmla="*/ 23685 w 197857"/>
                <a:gd name="connsiteY0" fmla="*/ 304800 h 304800"/>
                <a:gd name="connsiteX1" fmla="*/ 14977 w 197857"/>
                <a:gd name="connsiteY1" fmla="*/ 113211 h 304800"/>
                <a:gd name="connsiteX2" fmla="*/ 197857 w 197857"/>
                <a:gd name="connsiteY2" fmla="*/ 0 h 3048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97857" h="304800">
                  <a:moveTo>
                    <a:pt x="23685" y="304800"/>
                  </a:moveTo>
                  <a:cubicBezTo>
                    <a:pt x="4816" y="234405"/>
                    <a:pt x="-14052" y="164011"/>
                    <a:pt x="14977" y="113211"/>
                  </a:cubicBezTo>
                  <a:cubicBezTo>
                    <a:pt x="44006" y="62411"/>
                    <a:pt x="157217" y="18868"/>
                    <a:pt x="197857" y="0"/>
                  </a:cubicBezTo>
                </a:path>
              </a:pathLst>
            </a:custGeom>
            <a:noFill/>
            <a:ln w="38100">
              <a:solidFill>
                <a:srgbClr val="7030A0"/>
              </a:solidFill>
              <a:headEnd type="none" w="med" len="med"/>
              <a:tailEnd type="triangle" w="med" len="me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76FEADED-D580-4465-5AEA-FB4A7341F36B}"/>
                </a:ext>
              </a:extLst>
            </p:cNvPr>
            <p:cNvSpPr/>
            <p:nvPr/>
          </p:nvSpPr>
          <p:spPr>
            <a:xfrm>
              <a:off x="1447799" y="250371"/>
              <a:ext cx="6879771" cy="6297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C875A52-184D-B093-C33A-2EAFB478D616}"/>
              </a:ext>
            </a:extLst>
          </p:cNvPr>
          <p:cNvSpPr txBox="1"/>
          <p:nvPr/>
        </p:nvSpPr>
        <p:spPr>
          <a:xfrm>
            <a:off x="556235" y="6548171"/>
            <a:ext cx="8368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Supplementary Fig S1. </a:t>
            </a:r>
            <a:r>
              <a:rPr kumimoji="1" lang="en-US" altLang="ja-JP" sz="1400" dirty="0"/>
              <a:t>Major clusters in network of down-regulated genes in HEK 293 DOR by CM-10 treatment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560248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898</TotalTime>
  <Words>41</Words>
  <Application>Microsoft Office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直之 山本</dc:creator>
  <cp:lastModifiedBy>直之 山本</cp:lastModifiedBy>
  <cp:revision>70</cp:revision>
  <cp:lastPrinted>2024-06-28T04:04:42Z</cp:lastPrinted>
  <dcterms:created xsi:type="dcterms:W3CDTF">2023-09-21T01:48:30Z</dcterms:created>
  <dcterms:modified xsi:type="dcterms:W3CDTF">2025-10-04T04:03:01Z</dcterms:modified>
</cp:coreProperties>
</file>